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6" r:id="rId2"/>
  </p:sldIdLst>
  <p:sldSz cx="7772400" cy="10058400"/>
  <p:notesSz cx="7772400" cy="10058400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</p:embeddedFontLst>
  <p:defaultTextStyle/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2504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font" Target="fonts/font1.fntdata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5" Type="http://schemas.openxmlformats.org/officeDocument/2006/relationships/font" Target="fonts/font3.fntdata"/><Relationship Id="rId10" Type="http://schemas.openxmlformats.org/officeDocument/2006/relationships/tableStyles" Target="tableStyles.xml"/><Relationship Id="rId4" Type="http://schemas.openxmlformats.org/officeDocument/2006/relationships/font" Target="fonts/font2.fntdata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Freeform 103"/>
          <p:cNvSpPr/>
          <p:nvPr/>
        </p:nvSpPr>
        <p:spPr>
          <a:xfrm>
            <a:off x="228329" y="793021"/>
            <a:ext cx="7083425" cy="103759"/>
          </a:xfrm>
          <a:custGeom>
            <a:avLst/>
            <a:gdLst/>
            <a:ahLst/>
            <a:cxnLst/>
            <a:rect l="0" t="0" r="0" b="0"/>
            <a:pathLst>
              <a:path w="7083425" h="103759">
                <a:moveTo>
                  <a:pt x="3541648" y="0"/>
                </a:moveTo>
                <a:lnTo>
                  <a:pt x="7083425" y="0"/>
                </a:lnTo>
                <a:lnTo>
                  <a:pt x="7083425" y="103759"/>
                </a:lnTo>
                <a:lnTo>
                  <a:pt x="0" y="103759"/>
                </a:lnTo>
                <a:lnTo>
                  <a:pt x="0" y="0"/>
                </a:lnTo>
                <a:lnTo>
                  <a:pt x="3541648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4" name="Freeform 104"/>
          <p:cNvSpPr/>
          <p:nvPr/>
        </p:nvSpPr>
        <p:spPr>
          <a:xfrm>
            <a:off x="228329" y="902750"/>
            <a:ext cx="103631" cy="5285358"/>
          </a:xfrm>
          <a:custGeom>
            <a:avLst/>
            <a:gdLst/>
            <a:ahLst/>
            <a:cxnLst/>
            <a:rect l="0" t="0" r="0" b="0"/>
            <a:pathLst>
              <a:path w="103631" h="5285358">
                <a:moveTo>
                  <a:pt x="51815" y="0"/>
                </a:moveTo>
                <a:lnTo>
                  <a:pt x="103631" y="0"/>
                </a:lnTo>
                <a:lnTo>
                  <a:pt x="103631" y="5285358"/>
                </a:lnTo>
                <a:lnTo>
                  <a:pt x="0" y="5285358"/>
                </a:lnTo>
                <a:lnTo>
                  <a:pt x="0" y="0"/>
                </a:lnTo>
                <a:lnTo>
                  <a:pt x="5181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5" name="Freeform 105"/>
          <p:cNvSpPr/>
          <p:nvPr/>
        </p:nvSpPr>
        <p:spPr>
          <a:xfrm>
            <a:off x="338058" y="6084350"/>
            <a:ext cx="7083425" cy="103758"/>
          </a:xfrm>
          <a:custGeom>
            <a:avLst/>
            <a:gdLst/>
            <a:ahLst/>
            <a:cxnLst/>
            <a:rect l="0" t="0" r="0" b="0"/>
            <a:pathLst>
              <a:path w="7083425" h="103758">
                <a:moveTo>
                  <a:pt x="3541649" y="0"/>
                </a:moveTo>
                <a:lnTo>
                  <a:pt x="7083425" y="0"/>
                </a:lnTo>
                <a:lnTo>
                  <a:pt x="7083425" y="103758"/>
                </a:lnTo>
                <a:lnTo>
                  <a:pt x="0" y="103758"/>
                </a:lnTo>
                <a:lnTo>
                  <a:pt x="0" y="0"/>
                </a:lnTo>
                <a:lnTo>
                  <a:pt x="3541649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6" name="Freeform 106"/>
          <p:cNvSpPr/>
          <p:nvPr/>
        </p:nvSpPr>
        <p:spPr>
          <a:xfrm>
            <a:off x="7317977" y="793021"/>
            <a:ext cx="103506" cy="5285360"/>
          </a:xfrm>
          <a:custGeom>
            <a:avLst/>
            <a:gdLst/>
            <a:ahLst/>
            <a:cxnLst/>
            <a:rect l="0" t="0" r="0" b="0"/>
            <a:pathLst>
              <a:path w="103506" h="5285360">
                <a:moveTo>
                  <a:pt x="51689" y="0"/>
                </a:moveTo>
                <a:lnTo>
                  <a:pt x="103506" y="0"/>
                </a:lnTo>
                <a:lnTo>
                  <a:pt x="103506" y="5285360"/>
                </a:lnTo>
                <a:lnTo>
                  <a:pt x="0" y="5285360"/>
                </a:lnTo>
                <a:lnTo>
                  <a:pt x="0" y="0"/>
                </a:lnTo>
                <a:lnTo>
                  <a:pt x="51689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7" name="Freeform 107"/>
          <p:cNvSpPr/>
          <p:nvPr/>
        </p:nvSpPr>
        <p:spPr>
          <a:xfrm>
            <a:off x="904478" y="1106839"/>
            <a:ext cx="6407404" cy="3421887"/>
          </a:xfrm>
          <a:custGeom>
            <a:avLst/>
            <a:gdLst/>
            <a:ahLst/>
            <a:cxnLst/>
            <a:rect l="0" t="0" r="0" b="0"/>
            <a:pathLst>
              <a:path w="6407404" h="3421887">
                <a:moveTo>
                  <a:pt x="3203702" y="0"/>
                </a:moveTo>
                <a:lnTo>
                  <a:pt x="6407404" y="0"/>
                </a:lnTo>
                <a:lnTo>
                  <a:pt x="6407404" y="3421887"/>
                </a:lnTo>
                <a:lnTo>
                  <a:pt x="0" y="3421887"/>
                </a:lnTo>
                <a:lnTo>
                  <a:pt x="0" y="0"/>
                </a:lnTo>
                <a:lnTo>
                  <a:pt x="3203702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8" name="Freeform 108"/>
          <p:cNvSpPr/>
          <p:nvPr/>
        </p:nvSpPr>
        <p:spPr>
          <a:xfrm>
            <a:off x="904478" y="4458750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9" name="Freeform 109"/>
          <p:cNvSpPr/>
          <p:nvPr/>
        </p:nvSpPr>
        <p:spPr>
          <a:xfrm>
            <a:off x="904478" y="4239929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0" name="Freeform 110"/>
          <p:cNvSpPr/>
          <p:nvPr/>
        </p:nvSpPr>
        <p:spPr>
          <a:xfrm>
            <a:off x="904478" y="4021107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1" name="Freeform 111"/>
          <p:cNvSpPr/>
          <p:nvPr/>
        </p:nvSpPr>
        <p:spPr>
          <a:xfrm>
            <a:off x="904478" y="3802287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2" name="Freeform 112"/>
          <p:cNvSpPr/>
          <p:nvPr/>
        </p:nvSpPr>
        <p:spPr>
          <a:xfrm>
            <a:off x="904478" y="3583465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3" name="Freeform 113"/>
          <p:cNvSpPr/>
          <p:nvPr/>
        </p:nvSpPr>
        <p:spPr>
          <a:xfrm>
            <a:off x="904478" y="3364771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4" name="Freeform 114"/>
          <p:cNvSpPr/>
          <p:nvPr/>
        </p:nvSpPr>
        <p:spPr>
          <a:xfrm>
            <a:off x="904478" y="3145951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5" name="Freeform 115"/>
          <p:cNvSpPr/>
          <p:nvPr/>
        </p:nvSpPr>
        <p:spPr>
          <a:xfrm>
            <a:off x="904478" y="2927129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6" name="Freeform 116"/>
          <p:cNvSpPr/>
          <p:nvPr/>
        </p:nvSpPr>
        <p:spPr>
          <a:xfrm>
            <a:off x="904478" y="2708308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7" name="Freeform 117"/>
          <p:cNvSpPr/>
          <p:nvPr/>
        </p:nvSpPr>
        <p:spPr>
          <a:xfrm>
            <a:off x="904478" y="2489615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8" name="Freeform 118"/>
          <p:cNvSpPr/>
          <p:nvPr/>
        </p:nvSpPr>
        <p:spPr>
          <a:xfrm>
            <a:off x="904478" y="2270793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9" name="Freeform 119"/>
          <p:cNvSpPr/>
          <p:nvPr/>
        </p:nvSpPr>
        <p:spPr>
          <a:xfrm>
            <a:off x="904478" y="2051973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0" name="Freeform 120"/>
          <p:cNvSpPr/>
          <p:nvPr/>
        </p:nvSpPr>
        <p:spPr>
          <a:xfrm>
            <a:off x="904478" y="1833152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1" name="Freeform 121"/>
          <p:cNvSpPr/>
          <p:nvPr/>
        </p:nvSpPr>
        <p:spPr>
          <a:xfrm>
            <a:off x="904478" y="1614457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2" name="Freeform 122"/>
          <p:cNvSpPr/>
          <p:nvPr/>
        </p:nvSpPr>
        <p:spPr>
          <a:xfrm>
            <a:off x="904478" y="1395637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3" name="Freeform 123"/>
          <p:cNvSpPr/>
          <p:nvPr/>
        </p:nvSpPr>
        <p:spPr>
          <a:xfrm>
            <a:off x="904478" y="1176815"/>
            <a:ext cx="6401308" cy="0"/>
          </a:xfrm>
          <a:custGeom>
            <a:avLst/>
            <a:gdLst/>
            <a:ahLst/>
            <a:cxnLst/>
            <a:rect l="0" t="0" r="0" b="0"/>
            <a:pathLst>
              <a:path w="6401308">
                <a:moveTo>
                  <a:pt x="0" y="0"/>
                </a:moveTo>
                <a:lnTo>
                  <a:pt x="6401308" y="0"/>
                </a:lnTo>
              </a:path>
            </a:pathLst>
          </a:custGeom>
          <a:noFill/>
          <a:ln w="12191" cap="flat" cmpd="sng">
            <a:solidFill>
              <a:srgbClr val="ECECEC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4" name="Freeform 124"/>
          <p:cNvSpPr/>
          <p:nvPr/>
        </p:nvSpPr>
        <p:spPr>
          <a:xfrm>
            <a:off x="1476993" y="4047905"/>
            <a:ext cx="0" cy="12064"/>
          </a:xfrm>
          <a:custGeom>
            <a:avLst/>
            <a:gdLst/>
            <a:ahLst/>
            <a:cxnLst/>
            <a:rect l="0" t="0" r="0" b="0"/>
            <a:pathLst>
              <a:path h="12064">
                <a:moveTo>
                  <a:pt x="0" y="12064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5" name="Freeform 125"/>
          <p:cNvSpPr/>
          <p:nvPr/>
        </p:nvSpPr>
        <p:spPr>
          <a:xfrm>
            <a:off x="1476993" y="4047905"/>
            <a:ext cx="0" cy="12064"/>
          </a:xfrm>
          <a:custGeom>
            <a:avLst/>
            <a:gdLst/>
            <a:ahLst/>
            <a:cxnLst/>
            <a:rect l="0" t="0" r="0" b="0"/>
            <a:pathLst>
              <a:path h="12064">
                <a:moveTo>
                  <a:pt x="0" y="12064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6" name="Freeform 126"/>
          <p:cNvSpPr/>
          <p:nvPr/>
        </p:nvSpPr>
        <p:spPr>
          <a:xfrm>
            <a:off x="1476993" y="3305590"/>
            <a:ext cx="0" cy="13588"/>
          </a:xfrm>
          <a:custGeom>
            <a:avLst/>
            <a:gdLst/>
            <a:ahLst/>
            <a:cxnLst/>
            <a:rect l="0" t="0" r="0" b="0"/>
            <a:pathLst>
              <a:path h="13588">
                <a:moveTo>
                  <a:pt x="0" y="13588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7" name="Freeform 127"/>
          <p:cNvSpPr/>
          <p:nvPr/>
        </p:nvSpPr>
        <p:spPr>
          <a:xfrm>
            <a:off x="1476993" y="3305590"/>
            <a:ext cx="0" cy="13588"/>
          </a:xfrm>
          <a:custGeom>
            <a:avLst/>
            <a:gdLst/>
            <a:ahLst/>
            <a:cxnLst/>
            <a:rect l="0" t="0" r="0" b="0"/>
            <a:pathLst>
              <a:path h="13588">
                <a:moveTo>
                  <a:pt x="0" y="13588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8" name="Freeform 128"/>
          <p:cNvSpPr/>
          <p:nvPr/>
        </p:nvSpPr>
        <p:spPr>
          <a:xfrm>
            <a:off x="1476993" y="2127156"/>
            <a:ext cx="0" cy="30481"/>
          </a:xfrm>
          <a:custGeom>
            <a:avLst/>
            <a:gdLst/>
            <a:ahLst/>
            <a:cxnLst/>
            <a:rect l="0" t="0" r="0" b="0"/>
            <a:pathLst>
              <a:path h="30481">
                <a:moveTo>
                  <a:pt x="0" y="30481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9" name="Freeform 129"/>
          <p:cNvSpPr/>
          <p:nvPr/>
        </p:nvSpPr>
        <p:spPr>
          <a:xfrm>
            <a:off x="1476993" y="2127156"/>
            <a:ext cx="0" cy="30481"/>
          </a:xfrm>
          <a:custGeom>
            <a:avLst/>
            <a:gdLst/>
            <a:ahLst/>
            <a:cxnLst/>
            <a:rect l="0" t="0" r="0" b="0"/>
            <a:pathLst>
              <a:path h="30481">
                <a:moveTo>
                  <a:pt x="0" y="30481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0" name="Freeform 130"/>
          <p:cNvSpPr/>
          <p:nvPr/>
        </p:nvSpPr>
        <p:spPr>
          <a:xfrm>
            <a:off x="2529443" y="4065812"/>
            <a:ext cx="0" cy="11175"/>
          </a:xfrm>
          <a:custGeom>
            <a:avLst/>
            <a:gdLst/>
            <a:ahLst/>
            <a:cxnLst/>
            <a:rect l="0" t="0" r="0" b="0"/>
            <a:pathLst>
              <a:path h="11175">
                <a:moveTo>
                  <a:pt x="0" y="1117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1" name="Freeform 131"/>
          <p:cNvSpPr/>
          <p:nvPr/>
        </p:nvSpPr>
        <p:spPr>
          <a:xfrm>
            <a:off x="2529443" y="4065812"/>
            <a:ext cx="0" cy="11175"/>
          </a:xfrm>
          <a:custGeom>
            <a:avLst/>
            <a:gdLst/>
            <a:ahLst/>
            <a:cxnLst/>
            <a:rect l="0" t="0" r="0" b="0"/>
            <a:pathLst>
              <a:path h="11175">
                <a:moveTo>
                  <a:pt x="0" y="1117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2" name="Freeform 132"/>
          <p:cNvSpPr/>
          <p:nvPr/>
        </p:nvSpPr>
        <p:spPr>
          <a:xfrm>
            <a:off x="2529443" y="3324766"/>
            <a:ext cx="0" cy="11685"/>
          </a:xfrm>
          <a:custGeom>
            <a:avLst/>
            <a:gdLst/>
            <a:ahLst/>
            <a:cxnLst/>
            <a:rect l="0" t="0" r="0" b="0"/>
            <a:pathLst>
              <a:path h="11685">
                <a:moveTo>
                  <a:pt x="0" y="1168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3" name="Freeform 133"/>
          <p:cNvSpPr/>
          <p:nvPr/>
        </p:nvSpPr>
        <p:spPr>
          <a:xfrm>
            <a:off x="2529443" y="3324766"/>
            <a:ext cx="0" cy="11685"/>
          </a:xfrm>
          <a:custGeom>
            <a:avLst/>
            <a:gdLst/>
            <a:ahLst/>
            <a:cxnLst/>
            <a:rect l="0" t="0" r="0" b="0"/>
            <a:pathLst>
              <a:path h="11685">
                <a:moveTo>
                  <a:pt x="0" y="1168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4" name="Freeform 134"/>
          <p:cNvSpPr/>
          <p:nvPr/>
        </p:nvSpPr>
        <p:spPr>
          <a:xfrm>
            <a:off x="2529443" y="2052227"/>
            <a:ext cx="0" cy="28321"/>
          </a:xfrm>
          <a:custGeom>
            <a:avLst/>
            <a:gdLst/>
            <a:ahLst/>
            <a:cxnLst/>
            <a:rect l="0" t="0" r="0" b="0"/>
            <a:pathLst>
              <a:path h="28321">
                <a:moveTo>
                  <a:pt x="0" y="28321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5" name="Freeform 135"/>
          <p:cNvSpPr/>
          <p:nvPr/>
        </p:nvSpPr>
        <p:spPr>
          <a:xfrm>
            <a:off x="2529443" y="2052227"/>
            <a:ext cx="0" cy="28321"/>
          </a:xfrm>
          <a:custGeom>
            <a:avLst/>
            <a:gdLst/>
            <a:ahLst/>
            <a:cxnLst/>
            <a:rect l="0" t="0" r="0" b="0"/>
            <a:pathLst>
              <a:path h="28321">
                <a:moveTo>
                  <a:pt x="0" y="28321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6" name="Freeform 136"/>
          <p:cNvSpPr/>
          <p:nvPr/>
        </p:nvSpPr>
        <p:spPr>
          <a:xfrm>
            <a:off x="3581891" y="4055398"/>
            <a:ext cx="0" cy="10668"/>
          </a:xfrm>
          <a:custGeom>
            <a:avLst/>
            <a:gdLst/>
            <a:ahLst/>
            <a:cxnLst/>
            <a:rect l="0" t="0" r="0" b="0"/>
            <a:pathLst>
              <a:path h="10668">
                <a:moveTo>
                  <a:pt x="0" y="10668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7" name="Freeform 137"/>
          <p:cNvSpPr/>
          <p:nvPr/>
        </p:nvSpPr>
        <p:spPr>
          <a:xfrm>
            <a:off x="3581891" y="4055398"/>
            <a:ext cx="0" cy="10668"/>
          </a:xfrm>
          <a:custGeom>
            <a:avLst/>
            <a:gdLst/>
            <a:ahLst/>
            <a:cxnLst/>
            <a:rect l="0" t="0" r="0" b="0"/>
            <a:pathLst>
              <a:path h="10668">
                <a:moveTo>
                  <a:pt x="0" y="10668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8" name="Freeform 138"/>
          <p:cNvSpPr/>
          <p:nvPr/>
        </p:nvSpPr>
        <p:spPr>
          <a:xfrm>
            <a:off x="3581891" y="3331243"/>
            <a:ext cx="0" cy="11176"/>
          </a:xfrm>
          <a:custGeom>
            <a:avLst/>
            <a:gdLst/>
            <a:ahLst/>
            <a:cxnLst/>
            <a:rect l="0" t="0" r="0" b="0"/>
            <a:pathLst>
              <a:path h="11176">
                <a:moveTo>
                  <a:pt x="0" y="11176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9" name="Freeform 139"/>
          <p:cNvSpPr/>
          <p:nvPr/>
        </p:nvSpPr>
        <p:spPr>
          <a:xfrm>
            <a:off x="3581891" y="3331243"/>
            <a:ext cx="0" cy="11176"/>
          </a:xfrm>
          <a:custGeom>
            <a:avLst/>
            <a:gdLst/>
            <a:ahLst/>
            <a:cxnLst/>
            <a:rect l="0" t="0" r="0" b="0"/>
            <a:pathLst>
              <a:path h="11176">
                <a:moveTo>
                  <a:pt x="0" y="11176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0" name="Freeform 140"/>
          <p:cNvSpPr/>
          <p:nvPr/>
        </p:nvSpPr>
        <p:spPr>
          <a:xfrm>
            <a:off x="3581891" y="2084357"/>
            <a:ext cx="0" cy="29210"/>
          </a:xfrm>
          <a:custGeom>
            <a:avLst/>
            <a:gdLst/>
            <a:ahLst/>
            <a:cxnLst/>
            <a:rect l="0" t="0" r="0" b="0"/>
            <a:pathLst>
              <a:path h="29210">
                <a:moveTo>
                  <a:pt x="0" y="2921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1" name="Freeform 141"/>
          <p:cNvSpPr/>
          <p:nvPr/>
        </p:nvSpPr>
        <p:spPr>
          <a:xfrm>
            <a:off x="3581891" y="2084357"/>
            <a:ext cx="0" cy="29210"/>
          </a:xfrm>
          <a:custGeom>
            <a:avLst/>
            <a:gdLst/>
            <a:ahLst/>
            <a:cxnLst/>
            <a:rect l="0" t="0" r="0" b="0"/>
            <a:pathLst>
              <a:path h="29210">
                <a:moveTo>
                  <a:pt x="0" y="2921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2" name="Freeform 142"/>
          <p:cNvSpPr/>
          <p:nvPr/>
        </p:nvSpPr>
        <p:spPr>
          <a:xfrm>
            <a:off x="4634340" y="4044094"/>
            <a:ext cx="0" cy="12700"/>
          </a:xfrm>
          <a:custGeom>
            <a:avLst/>
            <a:gdLst/>
            <a:ahLst/>
            <a:cxnLst/>
            <a:rect l="0" t="0" r="0" b="0"/>
            <a:pathLst>
              <a:path h="12700">
                <a:moveTo>
                  <a:pt x="0" y="1270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3" name="Freeform 143"/>
          <p:cNvSpPr/>
          <p:nvPr/>
        </p:nvSpPr>
        <p:spPr>
          <a:xfrm>
            <a:off x="4634340" y="4044094"/>
            <a:ext cx="0" cy="12700"/>
          </a:xfrm>
          <a:custGeom>
            <a:avLst/>
            <a:gdLst/>
            <a:ahLst/>
            <a:cxnLst/>
            <a:rect l="0" t="0" r="0" b="0"/>
            <a:pathLst>
              <a:path h="12700">
                <a:moveTo>
                  <a:pt x="0" y="1270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4" name="Freeform 144"/>
          <p:cNvSpPr/>
          <p:nvPr/>
        </p:nvSpPr>
        <p:spPr>
          <a:xfrm>
            <a:off x="4634340" y="3285269"/>
            <a:ext cx="0" cy="13589"/>
          </a:xfrm>
          <a:custGeom>
            <a:avLst/>
            <a:gdLst/>
            <a:ahLst/>
            <a:cxnLst/>
            <a:rect l="0" t="0" r="0" b="0"/>
            <a:pathLst>
              <a:path h="13589">
                <a:moveTo>
                  <a:pt x="0" y="13589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5" name="Freeform 145"/>
          <p:cNvSpPr/>
          <p:nvPr/>
        </p:nvSpPr>
        <p:spPr>
          <a:xfrm>
            <a:off x="4634340" y="3285269"/>
            <a:ext cx="0" cy="13589"/>
          </a:xfrm>
          <a:custGeom>
            <a:avLst/>
            <a:gdLst/>
            <a:ahLst/>
            <a:cxnLst/>
            <a:rect l="0" t="0" r="0" b="0"/>
            <a:pathLst>
              <a:path h="13589">
                <a:moveTo>
                  <a:pt x="0" y="13589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6" name="Freeform 146"/>
          <p:cNvSpPr/>
          <p:nvPr/>
        </p:nvSpPr>
        <p:spPr>
          <a:xfrm>
            <a:off x="4634340" y="2170717"/>
            <a:ext cx="0" cy="32259"/>
          </a:xfrm>
          <a:custGeom>
            <a:avLst/>
            <a:gdLst/>
            <a:ahLst/>
            <a:cxnLst/>
            <a:rect l="0" t="0" r="0" b="0"/>
            <a:pathLst>
              <a:path h="32259">
                <a:moveTo>
                  <a:pt x="0" y="32259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7" name="Freeform 147"/>
          <p:cNvSpPr/>
          <p:nvPr/>
        </p:nvSpPr>
        <p:spPr>
          <a:xfrm>
            <a:off x="4634340" y="2170717"/>
            <a:ext cx="0" cy="32259"/>
          </a:xfrm>
          <a:custGeom>
            <a:avLst/>
            <a:gdLst/>
            <a:ahLst/>
            <a:cxnLst/>
            <a:rect l="0" t="0" r="0" b="0"/>
            <a:pathLst>
              <a:path h="32259">
                <a:moveTo>
                  <a:pt x="0" y="32259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8" name="Freeform 148"/>
          <p:cNvSpPr/>
          <p:nvPr/>
        </p:nvSpPr>
        <p:spPr>
          <a:xfrm>
            <a:off x="5686789" y="3989866"/>
            <a:ext cx="0" cy="17271"/>
          </a:xfrm>
          <a:custGeom>
            <a:avLst/>
            <a:gdLst/>
            <a:ahLst/>
            <a:cxnLst/>
            <a:rect l="0" t="0" r="0" b="0"/>
            <a:pathLst>
              <a:path h="17271">
                <a:moveTo>
                  <a:pt x="0" y="17271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9" name="Freeform 149"/>
          <p:cNvSpPr/>
          <p:nvPr/>
        </p:nvSpPr>
        <p:spPr>
          <a:xfrm>
            <a:off x="5686789" y="3989866"/>
            <a:ext cx="0" cy="17271"/>
          </a:xfrm>
          <a:custGeom>
            <a:avLst/>
            <a:gdLst/>
            <a:ahLst/>
            <a:cxnLst/>
            <a:rect l="0" t="0" r="0" b="0"/>
            <a:pathLst>
              <a:path h="17271">
                <a:moveTo>
                  <a:pt x="0" y="17271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0" name="Freeform 150"/>
          <p:cNvSpPr/>
          <p:nvPr/>
        </p:nvSpPr>
        <p:spPr>
          <a:xfrm>
            <a:off x="5686789" y="3361978"/>
            <a:ext cx="0" cy="16255"/>
          </a:xfrm>
          <a:custGeom>
            <a:avLst/>
            <a:gdLst/>
            <a:ahLst/>
            <a:cxnLst/>
            <a:rect l="0" t="0" r="0" b="0"/>
            <a:pathLst>
              <a:path h="16255">
                <a:moveTo>
                  <a:pt x="0" y="1625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1" name="Freeform 151"/>
          <p:cNvSpPr/>
          <p:nvPr/>
        </p:nvSpPr>
        <p:spPr>
          <a:xfrm>
            <a:off x="5686789" y="3361978"/>
            <a:ext cx="0" cy="16255"/>
          </a:xfrm>
          <a:custGeom>
            <a:avLst/>
            <a:gdLst/>
            <a:ahLst/>
            <a:cxnLst/>
            <a:rect l="0" t="0" r="0" b="0"/>
            <a:pathLst>
              <a:path h="16255">
                <a:moveTo>
                  <a:pt x="0" y="1625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2" name="Freeform 152"/>
          <p:cNvSpPr/>
          <p:nvPr/>
        </p:nvSpPr>
        <p:spPr>
          <a:xfrm>
            <a:off x="5686789" y="2493552"/>
            <a:ext cx="0" cy="33274"/>
          </a:xfrm>
          <a:custGeom>
            <a:avLst/>
            <a:gdLst/>
            <a:ahLst/>
            <a:cxnLst/>
            <a:rect l="0" t="0" r="0" b="0"/>
            <a:pathLst>
              <a:path h="33274">
                <a:moveTo>
                  <a:pt x="0" y="33274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3" name="Freeform 153"/>
          <p:cNvSpPr/>
          <p:nvPr/>
        </p:nvSpPr>
        <p:spPr>
          <a:xfrm>
            <a:off x="5686789" y="2493552"/>
            <a:ext cx="0" cy="33274"/>
          </a:xfrm>
          <a:custGeom>
            <a:avLst/>
            <a:gdLst/>
            <a:ahLst/>
            <a:cxnLst/>
            <a:rect l="0" t="0" r="0" b="0"/>
            <a:pathLst>
              <a:path h="33274">
                <a:moveTo>
                  <a:pt x="0" y="33274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4" name="Freeform 154"/>
          <p:cNvSpPr/>
          <p:nvPr/>
        </p:nvSpPr>
        <p:spPr>
          <a:xfrm>
            <a:off x="6739238" y="4073558"/>
            <a:ext cx="0" cy="18035"/>
          </a:xfrm>
          <a:custGeom>
            <a:avLst/>
            <a:gdLst/>
            <a:ahLst/>
            <a:cxnLst/>
            <a:rect l="0" t="0" r="0" b="0"/>
            <a:pathLst>
              <a:path h="18035">
                <a:moveTo>
                  <a:pt x="0" y="1803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5" name="Freeform 155"/>
          <p:cNvSpPr/>
          <p:nvPr/>
        </p:nvSpPr>
        <p:spPr>
          <a:xfrm>
            <a:off x="6739238" y="4073558"/>
            <a:ext cx="0" cy="18035"/>
          </a:xfrm>
          <a:custGeom>
            <a:avLst/>
            <a:gdLst/>
            <a:ahLst/>
            <a:cxnLst/>
            <a:rect l="0" t="0" r="0" b="0"/>
            <a:pathLst>
              <a:path h="18035">
                <a:moveTo>
                  <a:pt x="0" y="1803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6" name="Freeform 156"/>
          <p:cNvSpPr/>
          <p:nvPr/>
        </p:nvSpPr>
        <p:spPr>
          <a:xfrm>
            <a:off x="6739238" y="3530126"/>
            <a:ext cx="0" cy="14859"/>
          </a:xfrm>
          <a:custGeom>
            <a:avLst/>
            <a:gdLst/>
            <a:ahLst/>
            <a:cxnLst/>
            <a:rect l="0" t="0" r="0" b="0"/>
            <a:pathLst>
              <a:path h="14859">
                <a:moveTo>
                  <a:pt x="0" y="14859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7" name="Freeform 157"/>
          <p:cNvSpPr/>
          <p:nvPr/>
        </p:nvSpPr>
        <p:spPr>
          <a:xfrm>
            <a:off x="6739238" y="3530126"/>
            <a:ext cx="0" cy="14859"/>
          </a:xfrm>
          <a:custGeom>
            <a:avLst/>
            <a:gdLst/>
            <a:ahLst/>
            <a:cxnLst/>
            <a:rect l="0" t="0" r="0" b="0"/>
            <a:pathLst>
              <a:path h="14859">
                <a:moveTo>
                  <a:pt x="0" y="14859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8" name="Freeform 158"/>
          <p:cNvSpPr/>
          <p:nvPr/>
        </p:nvSpPr>
        <p:spPr>
          <a:xfrm>
            <a:off x="6739238" y="2644046"/>
            <a:ext cx="0" cy="33656"/>
          </a:xfrm>
          <a:custGeom>
            <a:avLst/>
            <a:gdLst/>
            <a:ahLst/>
            <a:cxnLst/>
            <a:rect l="0" t="0" r="0" b="0"/>
            <a:pathLst>
              <a:path h="33656">
                <a:moveTo>
                  <a:pt x="0" y="33656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9" name="Freeform 159"/>
          <p:cNvSpPr/>
          <p:nvPr/>
        </p:nvSpPr>
        <p:spPr>
          <a:xfrm>
            <a:off x="6739238" y="2644046"/>
            <a:ext cx="0" cy="33656"/>
          </a:xfrm>
          <a:custGeom>
            <a:avLst/>
            <a:gdLst/>
            <a:ahLst/>
            <a:cxnLst/>
            <a:rect l="0" t="0" r="0" b="0"/>
            <a:pathLst>
              <a:path h="33656">
                <a:moveTo>
                  <a:pt x="0" y="33656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0" name="Freeform 160"/>
          <p:cNvSpPr/>
          <p:nvPr/>
        </p:nvSpPr>
        <p:spPr>
          <a:xfrm>
            <a:off x="1416033" y="4047905"/>
            <a:ext cx="121794" cy="0"/>
          </a:xfrm>
          <a:custGeom>
            <a:avLst/>
            <a:gdLst/>
            <a:ahLst/>
            <a:cxnLst/>
            <a:rect l="0" t="0" r="0" b="0"/>
            <a:pathLst>
              <a:path w="121794">
                <a:moveTo>
                  <a:pt x="0" y="0"/>
                </a:moveTo>
                <a:lnTo>
                  <a:pt x="12179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1" name="Freeform 161"/>
          <p:cNvSpPr/>
          <p:nvPr/>
        </p:nvSpPr>
        <p:spPr>
          <a:xfrm>
            <a:off x="1416033" y="4047905"/>
            <a:ext cx="121794" cy="0"/>
          </a:xfrm>
          <a:custGeom>
            <a:avLst/>
            <a:gdLst/>
            <a:ahLst/>
            <a:cxnLst/>
            <a:rect l="0" t="0" r="0" b="0"/>
            <a:pathLst>
              <a:path w="121794">
                <a:moveTo>
                  <a:pt x="0" y="0"/>
                </a:moveTo>
                <a:lnTo>
                  <a:pt x="12179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2" name="Freeform 162"/>
          <p:cNvSpPr/>
          <p:nvPr/>
        </p:nvSpPr>
        <p:spPr>
          <a:xfrm>
            <a:off x="1416033" y="3305590"/>
            <a:ext cx="121794" cy="0"/>
          </a:xfrm>
          <a:custGeom>
            <a:avLst/>
            <a:gdLst/>
            <a:ahLst/>
            <a:cxnLst/>
            <a:rect l="0" t="0" r="0" b="0"/>
            <a:pathLst>
              <a:path w="121794">
                <a:moveTo>
                  <a:pt x="0" y="0"/>
                </a:moveTo>
                <a:lnTo>
                  <a:pt x="12179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3" name="Freeform 163"/>
          <p:cNvSpPr/>
          <p:nvPr/>
        </p:nvSpPr>
        <p:spPr>
          <a:xfrm>
            <a:off x="1416033" y="3305590"/>
            <a:ext cx="121794" cy="0"/>
          </a:xfrm>
          <a:custGeom>
            <a:avLst/>
            <a:gdLst/>
            <a:ahLst/>
            <a:cxnLst/>
            <a:rect l="0" t="0" r="0" b="0"/>
            <a:pathLst>
              <a:path w="121794">
                <a:moveTo>
                  <a:pt x="0" y="0"/>
                </a:moveTo>
                <a:lnTo>
                  <a:pt x="12179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4" name="Freeform 164"/>
          <p:cNvSpPr/>
          <p:nvPr/>
        </p:nvSpPr>
        <p:spPr>
          <a:xfrm>
            <a:off x="1416033" y="2127156"/>
            <a:ext cx="121794" cy="0"/>
          </a:xfrm>
          <a:custGeom>
            <a:avLst/>
            <a:gdLst/>
            <a:ahLst/>
            <a:cxnLst/>
            <a:rect l="0" t="0" r="0" b="0"/>
            <a:pathLst>
              <a:path w="121794">
                <a:moveTo>
                  <a:pt x="0" y="0"/>
                </a:moveTo>
                <a:lnTo>
                  <a:pt x="12179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5" name="Freeform 165"/>
          <p:cNvSpPr/>
          <p:nvPr/>
        </p:nvSpPr>
        <p:spPr>
          <a:xfrm>
            <a:off x="1416033" y="2127156"/>
            <a:ext cx="121794" cy="0"/>
          </a:xfrm>
          <a:custGeom>
            <a:avLst/>
            <a:gdLst/>
            <a:ahLst/>
            <a:cxnLst/>
            <a:rect l="0" t="0" r="0" b="0"/>
            <a:pathLst>
              <a:path w="121794">
                <a:moveTo>
                  <a:pt x="0" y="0"/>
                </a:moveTo>
                <a:lnTo>
                  <a:pt x="12179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6" name="Freeform 166"/>
          <p:cNvSpPr/>
          <p:nvPr/>
        </p:nvSpPr>
        <p:spPr>
          <a:xfrm>
            <a:off x="2468482" y="4065812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7" name="Freeform 167"/>
          <p:cNvSpPr/>
          <p:nvPr/>
        </p:nvSpPr>
        <p:spPr>
          <a:xfrm>
            <a:off x="2468482" y="4065812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8" name="Freeform 168"/>
          <p:cNvSpPr/>
          <p:nvPr/>
        </p:nvSpPr>
        <p:spPr>
          <a:xfrm>
            <a:off x="2468482" y="3324766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9" name="Freeform 169"/>
          <p:cNvSpPr/>
          <p:nvPr/>
        </p:nvSpPr>
        <p:spPr>
          <a:xfrm>
            <a:off x="2468482" y="3324766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0" name="Freeform 170"/>
          <p:cNvSpPr/>
          <p:nvPr/>
        </p:nvSpPr>
        <p:spPr>
          <a:xfrm>
            <a:off x="2468482" y="2052227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1" name="Freeform 171"/>
          <p:cNvSpPr/>
          <p:nvPr/>
        </p:nvSpPr>
        <p:spPr>
          <a:xfrm>
            <a:off x="2468482" y="2052227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2" name="Freeform 172"/>
          <p:cNvSpPr/>
          <p:nvPr/>
        </p:nvSpPr>
        <p:spPr>
          <a:xfrm>
            <a:off x="3520932" y="4055398"/>
            <a:ext cx="121919" cy="0"/>
          </a:xfrm>
          <a:custGeom>
            <a:avLst/>
            <a:gdLst/>
            <a:ahLst/>
            <a:cxnLst/>
            <a:rect l="0" t="0" r="0" b="0"/>
            <a:pathLst>
              <a:path w="121919">
                <a:moveTo>
                  <a:pt x="0" y="0"/>
                </a:moveTo>
                <a:lnTo>
                  <a:pt x="12191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3" name="Freeform 173"/>
          <p:cNvSpPr/>
          <p:nvPr/>
        </p:nvSpPr>
        <p:spPr>
          <a:xfrm>
            <a:off x="3520932" y="4055398"/>
            <a:ext cx="121919" cy="0"/>
          </a:xfrm>
          <a:custGeom>
            <a:avLst/>
            <a:gdLst/>
            <a:ahLst/>
            <a:cxnLst/>
            <a:rect l="0" t="0" r="0" b="0"/>
            <a:pathLst>
              <a:path w="121919">
                <a:moveTo>
                  <a:pt x="0" y="0"/>
                </a:moveTo>
                <a:lnTo>
                  <a:pt x="12191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4" name="Freeform 174"/>
          <p:cNvSpPr/>
          <p:nvPr/>
        </p:nvSpPr>
        <p:spPr>
          <a:xfrm>
            <a:off x="3520932" y="3331243"/>
            <a:ext cx="121919" cy="0"/>
          </a:xfrm>
          <a:custGeom>
            <a:avLst/>
            <a:gdLst/>
            <a:ahLst/>
            <a:cxnLst/>
            <a:rect l="0" t="0" r="0" b="0"/>
            <a:pathLst>
              <a:path w="121919">
                <a:moveTo>
                  <a:pt x="0" y="0"/>
                </a:moveTo>
                <a:lnTo>
                  <a:pt x="12191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5" name="Freeform 175"/>
          <p:cNvSpPr/>
          <p:nvPr/>
        </p:nvSpPr>
        <p:spPr>
          <a:xfrm>
            <a:off x="3520932" y="3331243"/>
            <a:ext cx="121919" cy="0"/>
          </a:xfrm>
          <a:custGeom>
            <a:avLst/>
            <a:gdLst/>
            <a:ahLst/>
            <a:cxnLst/>
            <a:rect l="0" t="0" r="0" b="0"/>
            <a:pathLst>
              <a:path w="121919">
                <a:moveTo>
                  <a:pt x="0" y="0"/>
                </a:moveTo>
                <a:lnTo>
                  <a:pt x="12191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6" name="Freeform 176"/>
          <p:cNvSpPr/>
          <p:nvPr/>
        </p:nvSpPr>
        <p:spPr>
          <a:xfrm>
            <a:off x="3520932" y="2084357"/>
            <a:ext cx="121919" cy="0"/>
          </a:xfrm>
          <a:custGeom>
            <a:avLst/>
            <a:gdLst/>
            <a:ahLst/>
            <a:cxnLst/>
            <a:rect l="0" t="0" r="0" b="0"/>
            <a:pathLst>
              <a:path w="121919">
                <a:moveTo>
                  <a:pt x="0" y="0"/>
                </a:moveTo>
                <a:lnTo>
                  <a:pt x="12191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7" name="Freeform 177"/>
          <p:cNvSpPr/>
          <p:nvPr/>
        </p:nvSpPr>
        <p:spPr>
          <a:xfrm>
            <a:off x="3520932" y="2084357"/>
            <a:ext cx="121919" cy="0"/>
          </a:xfrm>
          <a:custGeom>
            <a:avLst/>
            <a:gdLst/>
            <a:ahLst/>
            <a:cxnLst/>
            <a:rect l="0" t="0" r="0" b="0"/>
            <a:pathLst>
              <a:path w="121919">
                <a:moveTo>
                  <a:pt x="0" y="0"/>
                </a:moveTo>
                <a:lnTo>
                  <a:pt x="12191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8" name="Freeform 178"/>
          <p:cNvSpPr/>
          <p:nvPr/>
        </p:nvSpPr>
        <p:spPr>
          <a:xfrm>
            <a:off x="4573508" y="4044094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9" name="Freeform 179"/>
          <p:cNvSpPr/>
          <p:nvPr/>
        </p:nvSpPr>
        <p:spPr>
          <a:xfrm>
            <a:off x="4573508" y="4044094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0" name="Freeform 180"/>
          <p:cNvSpPr/>
          <p:nvPr/>
        </p:nvSpPr>
        <p:spPr>
          <a:xfrm>
            <a:off x="4573508" y="3285269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1" name="Freeform 181"/>
          <p:cNvSpPr/>
          <p:nvPr/>
        </p:nvSpPr>
        <p:spPr>
          <a:xfrm>
            <a:off x="4573508" y="3285269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2" name="Freeform 182"/>
          <p:cNvSpPr/>
          <p:nvPr/>
        </p:nvSpPr>
        <p:spPr>
          <a:xfrm>
            <a:off x="4573508" y="2170717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3" name="Freeform 183"/>
          <p:cNvSpPr/>
          <p:nvPr/>
        </p:nvSpPr>
        <p:spPr>
          <a:xfrm>
            <a:off x="4573508" y="2170717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4" name="Freeform 184"/>
          <p:cNvSpPr/>
          <p:nvPr/>
        </p:nvSpPr>
        <p:spPr>
          <a:xfrm>
            <a:off x="5625957" y="3989866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5" name="Freeform 185"/>
          <p:cNvSpPr/>
          <p:nvPr/>
        </p:nvSpPr>
        <p:spPr>
          <a:xfrm>
            <a:off x="5625957" y="3989866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6" name="Freeform 186"/>
          <p:cNvSpPr/>
          <p:nvPr/>
        </p:nvSpPr>
        <p:spPr>
          <a:xfrm>
            <a:off x="5625957" y="3361978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7" name="Freeform 187"/>
          <p:cNvSpPr/>
          <p:nvPr/>
        </p:nvSpPr>
        <p:spPr>
          <a:xfrm>
            <a:off x="5625957" y="3361978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8" name="Freeform 188"/>
          <p:cNvSpPr/>
          <p:nvPr/>
        </p:nvSpPr>
        <p:spPr>
          <a:xfrm>
            <a:off x="5625957" y="2493552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9" name="Freeform 189"/>
          <p:cNvSpPr/>
          <p:nvPr/>
        </p:nvSpPr>
        <p:spPr>
          <a:xfrm>
            <a:off x="5625957" y="2493552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0" name="Freeform 190"/>
          <p:cNvSpPr/>
          <p:nvPr/>
        </p:nvSpPr>
        <p:spPr>
          <a:xfrm>
            <a:off x="6678406" y="4073558"/>
            <a:ext cx="121792" cy="0"/>
          </a:xfrm>
          <a:custGeom>
            <a:avLst/>
            <a:gdLst/>
            <a:ahLst/>
            <a:cxnLst/>
            <a:rect l="0" t="0" r="0" b="0"/>
            <a:pathLst>
              <a:path w="121792">
                <a:moveTo>
                  <a:pt x="0" y="0"/>
                </a:moveTo>
                <a:lnTo>
                  <a:pt x="121792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1" name="Freeform 191"/>
          <p:cNvSpPr/>
          <p:nvPr/>
        </p:nvSpPr>
        <p:spPr>
          <a:xfrm>
            <a:off x="6678406" y="4073558"/>
            <a:ext cx="121792" cy="0"/>
          </a:xfrm>
          <a:custGeom>
            <a:avLst/>
            <a:gdLst/>
            <a:ahLst/>
            <a:cxnLst/>
            <a:rect l="0" t="0" r="0" b="0"/>
            <a:pathLst>
              <a:path w="121792">
                <a:moveTo>
                  <a:pt x="0" y="0"/>
                </a:moveTo>
                <a:lnTo>
                  <a:pt x="121792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2" name="Freeform 192"/>
          <p:cNvSpPr/>
          <p:nvPr/>
        </p:nvSpPr>
        <p:spPr>
          <a:xfrm>
            <a:off x="6678406" y="3530126"/>
            <a:ext cx="121792" cy="0"/>
          </a:xfrm>
          <a:custGeom>
            <a:avLst/>
            <a:gdLst/>
            <a:ahLst/>
            <a:cxnLst/>
            <a:rect l="0" t="0" r="0" b="0"/>
            <a:pathLst>
              <a:path w="121792">
                <a:moveTo>
                  <a:pt x="0" y="0"/>
                </a:moveTo>
                <a:lnTo>
                  <a:pt x="121792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3" name="Freeform 193"/>
          <p:cNvSpPr/>
          <p:nvPr/>
        </p:nvSpPr>
        <p:spPr>
          <a:xfrm>
            <a:off x="6678406" y="3530126"/>
            <a:ext cx="121792" cy="0"/>
          </a:xfrm>
          <a:custGeom>
            <a:avLst/>
            <a:gdLst/>
            <a:ahLst/>
            <a:cxnLst/>
            <a:rect l="0" t="0" r="0" b="0"/>
            <a:pathLst>
              <a:path w="121792">
                <a:moveTo>
                  <a:pt x="0" y="0"/>
                </a:moveTo>
                <a:lnTo>
                  <a:pt x="121792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4" name="Freeform 194"/>
          <p:cNvSpPr/>
          <p:nvPr/>
        </p:nvSpPr>
        <p:spPr>
          <a:xfrm>
            <a:off x="6678406" y="2644046"/>
            <a:ext cx="121792" cy="0"/>
          </a:xfrm>
          <a:custGeom>
            <a:avLst/>
            <a:gdLst/>
            <a:ahLst/>
            <a:cxnLst/>
            <a:rect l="0" t="0" r="0" b="0"/>
            <a:pathLst>
              <a:path w="121792">
                <a:moveTo>
                  <a:pt x="0" y="0"/>
                </a:moveTo>
                <a:lnTo>
                  <a:pt x="121792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5" name="Freeform 195"/>
          <p:cNvSpPr/>
          <p:nvPr/>
        </p:nvSpPr>
        <p:spPr>
          <a:xfrm>
            <a:off x="6678406" y="2644046"/>
            <a:ext cx="121792" cy="0"/>
          </a:xfrm>
          <a:custGeom>
            <a:avLst/>
            <a:gdLst/>
            <a:ahLst/>
            <a:cxnLst/>
            <a:rect l="0" t="0" r="0" b="0"/>
            <a:pathLst>
              <a:path w="121792">
                <a:moveTo>
                  <a:pt x="0" y="0"/>
                </a:moveTo>
                <a:lnTo>
                  <a:pt x="121792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6" name="Freeform 196"/>
          <p:cNvSpPr/>
          <p:nvPr/>
        </p:nvSpPr>
        <p:spPr>
          <a:xfrm>
            <a:off x="1476993" y="4059969"/>
            <a:ext cx="0" cy="11938"/>
          </a:xfrm>
          <a:custGeom>
            <a:avLst/>
            <a:gdLst/>
            <a:ahLst/>
            <a:cxnLst/>
            <a:rect l="0" t="0" r="0" b="0"/>
            <a:pathLst>
              <a:path h="11938">
                <a:moveTo>
                  <a:pt x="0" y="0"/>
                </a:moveTo>
                <a:lnTo>
                  <a:pt x="0" y="11938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7" name="Freeform 197"/>
          <p:cNvSpPr/>
          <p:nvPr/>
        </p:nvSpPr>
        <p:spPr>
          <a:xfrm>
            <a:off x="1476993" y="3319178"/>
            <a:ext cx="0" cy="13462"/>
          </a:xfrm>
          <a:custGeom>
            <a:avLst/>
            <a:gdLst/>
            <a:ahLst/>
            <a:cxnLst/>
            <a:rect l="0" t="0" r="0" b="0"/>
            <a:pathLst>
              <a:path h="13462">
                <a:moveTo>
                  <a:pt x="0" y="0"/>
                </a:moveTo>
                <a:lnTo>
                  <a:pt x="0" y="13462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8" name="Freeform 198"/>
          <p:cNvSpPr/>
          <p:nvPr/>
        </p:nvSpPr>
        <p:spPr>
          <a:xfrm>
            <a:off x="1476993" y="2157637"/>
            <a:ext cx="0" cy="30606"/>
          </a:xfrm>
          <a:custGeom>
            <a:avLst/>
            <a:gdLst/>
            <a:ahLst/>
            <a:cxnLst/>
            <a:rect l="0" t="0" r="0" b="0"/>
            <a:pathLst>
              <a:path h="30606">
                <a:moveTo>
                  <a:pt x="0" y="0"/>
                </a:moveTo>
                <a:lnTo>
                  <a:pt x="0" y="30606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9" name="Freeform 199"/>
          <p:cNvSpPr/>
          <p:nvPr/>
        </p:nvSpPr>
        <p:spPr>
          <a:xfrm>
            <a:off x="2529443" y="4076987"/>
            <a:ext cx="0" cy="11304"/>
          </a:xfrm>
          <a:custGeom>
            <a:avLst/>
            <a:gdLst/>
            <a:ahLst/>
            <a:cxnLst/>
            <a:rect l="0" t="0" r="0" b="0"/>
            <a:pathLst>
              <a:path h="11304">
                <a:moveTo>
                  <a:pt x="0" y="0"/>
                </a:moveTo>
                <a:lnTo>
                  <a:pt x="0" y="11304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0" name="Freeform 200"/>
          <p:cNvSpPr/>
          <p:nvPr/>
        </p:nvSpPr>
        <p:spPr>
          <a:xfrm>
            <a:off x="2529443" y="3336451"/>
            <a:ext cx="0" cy="11811"/>
          </a:xfrm>
          <a:custGeom>
            <a:avLst/>
            <a:gdLst/>
            <a:ahLst/>
            <a:cxnLst/>
            <a:rect l="0" t="0" r="0" b="0"/>
            <a:pathLst>
              <a:path h="11811">
                <a:moveTo>
                  <a:pt x="0" y="0"/>
                </a:moveTo>
                <a:lnTo>
                  <a:pt x="0" y="11811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1" name="Freeform 201"/>
          <p:cNvSpPr/>
          <p:nvPr/>
        </p:nvSpPr>
        <p:spPr>
          <a:xfrm>
            <a:off x="2529443" y="2080548"/>
            <a:ext cx="0" cy="28320"/>
          </a:xfrm>
          <a:custGeom>
            <a:avLst/>
            <a:gdLst/>
            <a:ahLst/>
            <a:cxnLst/>
            <a:rect l="0" t="0" r="0" b="0"/>
            <a:pathLst>
              <a:path h="28320">
                <a:moveTo>
                  <a:pt x="0" y="0"/>
                </a:moveTo>
                <a:lnTo>
                  <a:pt x="0" y="2832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2" name="Freeform 202"/>
          <p:cNvSpPr/>
          <p:nvPr/>
        </p:nvSpPr>
        <p:spPr>
          <a:xfrm>
            <a:off x="3581891" y="4066066"/>
            <a:ext cx="0" cy="10795"/>
          </a:xfrm>
          <a:custGeom>
            <a:avLst/>
            <a:gdLst/>
            <a:ahLst/>
            <a:cxnLst/>
            <a:rect l="0" t="0" r="0" b="0"/>
            <a:pathLst>
              <a:path h="10795">
                <a:moveTo>
                  <a:pt x="0" y="0"/>
                </a:moveTo>
                <a:lnTo>
                  <a:pt x="0" y="10795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3" name="Freeform 203"/>
          <p:cNvSpPr/>
          <p:nvPr/>
        </p:nvSpPr>
        <p:spPr>
          <a:xfrm>
            <a:off x="3581891" y="3342419"/>
            <a:ext cx="0" cy="11176"/>
          </a:xfrm>
          <a:custGeom>
            <a:avLst/>
            <a:gdLst/>
            <a:ahLst/>
            <a:cxnLst/>
            <a:rect l="0" t="0" r="0" b="0"/>
            <a:pathLst>
              <a:path h="11176">
                <a:moveTo>
                  <a:pt x="0" y="0"/>
                </a:moveTo>
                <a:lnTo>
                  <a:pt x="0" y="11176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4" name="Freeform 204"/>
          <p:cNvSpPr/>
          <p:nvPr/>
        </p:nvSpPr>
        <p:spPr>
          <a:xfrm>
            <a:off x="3581891" y="2113567"/>
            <a:ext cx="0" cy="29084"/>
          </a:xfrm>
          <a:custGeom>
            <a:avLst/>
            <a:gdLst/>
            <a:ahLst/>
            <a:cxnLst/>
            <a:rect l="0" t="0" r="0" b="0"/>
            <a:pathLst>
              <a:path h="29084">
                <a:moveTo>
                  <a:pt x="0" y="0"/>
                </a:moveTo>
                <a:lnTo>
                  <a:pt x="0" y="29084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5" name="Freeform 205"/>
          <p:cNvSpPr/>
          <p:nvPr/>
        </p:nvSpPr>
        <p:spPr>
          <a:xfrm>
            <a:off x="4634340" y="4056794"/>
            <a:ext cx="0" cy="12574"/>
          </a:xfrm>
          <a:custGeom>
            <a:avLst/>
            <a:gdLst/>
            <a:ahLst/>
            <a:cxnLst/>
            <a:rect l="0" t="0" r="0" b="0"/>
            <a:pathLst>
              <a:path h="12574">
                <a:moveTo>
                  <a:pt x="0" y="0"/>
                </a:moveTo>
                <a:lnTo>
                  <a:pt x="0" y="12574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6" name="Freeform 206"/>
          <p:cNvSpPr/>
          <p:nvPr/>
        </p:nvSpPr>
        <p:spPr>
          <a:xfrm>
            <a:off x="4634340" y="3298858"/>
            <a:ext cx="0" cy="13717"/>
          </a:xfrm>
          <a:custGeom>
            <a:avLst/>
            <a:gdLst/>
            <a:ahLst/>
            <a:cxnLst/>
            <a:rect l="0" t="0" r="0" b="0"/>
            <a:pathLst>
              <a:path h="13717">
                <a:moveTo>
                  <a:pt x="0" y="0"/>
                </a:moveTo>
                <a:lnTo>
                  <a:pt x="0" y="13717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7" name="Freeform 207"/>
          <p:cNvSpPr/>
          <p:nvPr/>
        </p:nvSpPr>
        <p:spPr>
          <a:xfrm>
            <a:off x="4634340" y="2202976"/>
            <a:ext cx="0" cy="32130"/>
          </a:xfrm>
          <a:custGeom>
            <a:avLst/>
            <a:gdLst/>
            <a:ahLst/>
            <a:cxnLst/>
            <a:rect l="0" t="0" r="0" b="0"/>
            <a:pathLst>
              <a:path h="32130">
                <a:moveTo>
                  <a:pt x="0" y="0"/>
                </a:moveTo>
                <a:lnTo>
                  <a:pt x="0" y="3213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8" name="Freeform 208"/>
          <p:cNvSpPr/>
          <p:nvPr/>
        </p:nvSpPr>
        <p:spPr>
          <a:xfrm>
            <a:off x="5686789" y="4007137"/>
            <a:ext cx="0" cy="17145"/>
          </a:xfrm>
          <a:custGeom>
            <a:avLst/>
            <a:gdLst/>
            <a:ahLst/>
            <a:cxnLst/>
            <a:rect l="0" t="0" r="0" b="0"/>
            <a:pathLst>
              <a:path h="17145">
                <a:moveTo>
                  <a:pt x="0" y="0"/>
                </a:moveTo>
                <a:lnTo>
                  <a:pt x="0" y="17145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9" name="Freeform 209"/>
          <p:cNvSpPr/>
          <p:nvPr/>
        </p:nvSpPr>
        <p:spPr>
          <a:xfrm>
            <a:off x="5686789" y="3378233"/>
            <a:ext cx="0" cy="16257"/>
          </a:xfrm>
          <a:custGeom>
            <a:avLst/>
            <a:gdLst/>
            <a:ahLst/>
            <a:cxnLst/>
            <a:rect l="0" t="0" r="0" b="0"/>
            <a:pathLst>
              <a:path h="16257">
                <a:moveTo>
                  <a:pt x="0" y="0"/>
                </a:moveTo>
                <a:lnTo>
                  <a:pt x="0" y="16257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0" name="Freeform 210"/>
          <p:cNvSpPr/>
          <p:nvPr/>
        </p:nvSpPr>
        <p:spPr>
          <a:xfrm>
            <a:off x="5686789" y="2526826"/>
            <a:ext cx="0" cy="33274"/>
          </a:xfrm>
          <a:custGeom>
            <a:avLst/>
            <a:gdLst/>
            <a:ahLst/>
            <a:cxnLst/>
            <a:rect l="0" t="0" r="0" b="0"/>
            <a:pathLst>
              <a:path h="33274">
                <a:moveTo>
                  <a:pt x="0" y="0"/>
                </a:moveTo>
                <a:lnTo>
                  <a:pt x="0" y="33274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1" name="Freeform 211"/>
          <p:cNvSpPr/>
          <p:nvPr/>
        </p:nvSpPr>
        <p:spPr>
          <a:xfrm>
            <a:off x="6739238" y="4091593"/>
            <a:ext cx="0" cy="18033"/>
          </a:xfrm>
          <a:custGeom>
            <a:avLst/>
            <a:gdLst/>
            <a:ahLst/>
            <a:cxnLst/>
            <a:rect l="0" t="0" r="0" b="0"/>
            <a:pathLst>
              <a:path h="18033">
                <a:moveTo>
                  <a:pt x="0" y="0"/>
                </a:moveTo>
                <a:lnTo>
                  <a:pt x="0" y="18033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2" name="Freeform 212"/>
          <p:cNvSpPr/>
          <p:nvPr/>
        </p:nvSpPr>
        <p:spPr>
          <a:xfrm>
            <a:off x="6739238" y="3544985"/>
            <a:ext cx="0" cy="14858"/>
          </a:xfrm>
          <a:custGeom>
            <a:avLst/>
            <a:gdLst/>
            <a:ahLst/>
            <a:cxnLst/>
            <a:rect l="0" t="0" r="0" b="0"/>
            <a:pathLst>
              <a:path h="14858">
                <a:moveTo>
                  <a:pt x="0" y="0"/>
                </a:moveTo>
                <a:lnTo>
                  <a:pt x="0" y="14858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3" name="Freeform 213"/>
          <p:cNvSpPr/>
          <p:nvPr/>
        </p:nvSpPr>
        <p:spPr>
          <a:xfrm>
            <a:off x="6739238" y="2677702"/>
            <a:ext cx="0" cy="33654"/>
          </a:xfrm>
          <a:custGeom>
            <a:avLst/>
            <a:gdLst/>
            <a:ahLst/>
            <a:cxnLst/>
            <a:rect l="0" t="0" r="0" b="0"/>
            <a:pathLst>
              <a:path h="33654">
                <a:moveTo>
                  <a:pt x="0" y="0"/>
                </a:moveTo>
                <a:lnTo>
                  <a:pt x="0" y="33654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4" name="Freeform 214"/>
          <p:cNvSpPr/>
          <p:nvPr/>
        </p:nvSpPr>
        <p:spPr>
          <a:xfrm>
            <a:off x="1416033" y="4071907"/>
            <a:ext cx="121794" cy="0"/>
          </a:xfrm>
          <a:custGeom>
            <a:avLst/>
            <a:gdLst/>
            <a:ahLst/>
            <a:cxnLst/>
            <a:rect l="0" t="0" r="0" b="0"/>
            <a:pathLst>
              <a:path w="121794">
                <a:moveTo>
                  <a:pt x="0" y="0"/>
                </a:moveTo>
                <a:lnTo>
                  <a:pt x="12179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5" name="Freeform 215"/>
          <p:cNvSpPr/>
          <p:nvPr/>
        </p:nvSpPr>
        <p:spPr>
          <a:xfrm>
            <a:off x="1416033" y="3332640"/>
            <a:ext cx="121794" cy="0"/>
          </a:xfrm>
          <a:custGeom>
            <a:avLst/>
            <a:gdLst/>
            <a:ahLst/>
            <a:cxnLst/>
            <a:rect l="0" t="0" r="0" b="0"/>
            <a:pathLst>
              <a:path w="121794">
                <a:moveTo>
                  <a:pt x="0" y="0"/>
                </a:moveTo>
                <a:lnTo>
                  <a:pt x="12179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6" name="Freeform 216"/>
          <p:cNvSpPr/>
          <p:nvPr/>
        </p:nvSpPr>
        <p:spPr>
          <a:xfrm>
            <a:off x="1416033" y="2188243"/>
            <a:ext cx="121794" cy="0"/>
          </a:xfrm>
          <a:custGeom>
            <a:avLst/>
            <a:gdLst/>
            <a:ahLst/>
            <a:cxnLst/>
            <a:rect l="0" t="0" r="0" b="0"/>
            <a:pathLst>
              <a:path w="121794">
                <a:moveTo>
                  <a:pt x="0" y="0"/>
                </a:moveTo>
                <a:lnTo>
                  <a:pt x="12179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7" name="Freeform 217"/>
          <p:cNvSpPr/>
          <p:nvPr/>
        </p:nvSpPr>
        <p:spPr>
          <a:xfrm>
            <a:off x="2468482" y="4088291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8" name="Freeform 218"/>
          <p:cNvSpPr/>
          <p:nvPr/>
        </p:nvSpPr>
        <p:spPr>
          <a:xfrm>
            <a:off x="2468482" y="3348262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9" name="Freeform 219"/>
          <p:cNvSpPr/>
          <p:nvPr/>
        </p:nvSpPr>
        <p:spPr>
          <a:xfrm>
            <a:off x="2468482" y="2108868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0" name="Freeform 220"/>
          <p:cNvSpPr/>
          <p:nvPr/>
        </p:nvSpPr>
        <p:spPr>
          <a:xfrm>
            <a:off x="3520932" y="4076861"/>
            <a:ext cx="121919" cy="0"/>
          </a:xfrm>
          <a:custGeom>
            <a:avLst/>
            <a:gdLst/>
            <a:ahLst/>
            <a:cxnLst/>
            <a:rect l="0" t="0" r="0" b="0"/>
            <a:pathLst>
              <a:path w="121919">
                <a:moveTo>
                  <a:pt x="0" y="0"/>
                </a:moveTo>
                <a:lnTo>
                  <a:pt x="12191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1" name="Freeform 221"/>
          <p:cNvSpPr/>
          <p:nvPr/>
        </p:nvSpPr>
        <p:spPr>
          <a:xfrm>
            <a:off x="3520932" y="3353595"/>
            <a:ext cx="121919" cy="0"/>
          </a:xfrm>
          <a:custGeom>
            <a:avLst/>
            <a:gdLst/>
            <a:ahLst/>
            <a:cxnLst/>
            <a:rect l="0" t="0" r="0" b="0"/>
            <a:pathLst>
              <a:path w="121919">
                <a:moveTo>
                  <a:pt x="0" y="0"/>
                </a:moveTo>
                <a:lnTo>
                  <a:pt x="12191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2" name="Freeform 222"/>
          <p:cNvSpPr/>
          <p:nvPr/>
        </p:nvSpPr>
        <p:spPr>
          <a:xfrm>
            <a:off x="3520932" y="2142651"/>
            <a:ext cx="121919" cy="0"/>
          </a:xfrm>
          <a:custGeom>
            <a:avLst/>
            <a:gdLst/>
            <a:ahLst/>
            <a:cxnLst/>
            <a:rect l="0" t="0" r="0" b="0"/>
            <a:pathLst>
              <a:path w="121919">
                <a:moveTo>
                  <a:pt x="0" y="0"/>
                </a:moveTo>
                <a:lnTo>
                  <a:pt x="12191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3" name="Freeform 223"/>
          <p:cNvSpPr/>
          <p:nvPr/>
        </p:nvSpPr>
        <p:spPr>
          <a:xfrm>
            <a:off x="4573508" y="4069368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4" name="Freeform 224"/>
          <p:cNvSpPr/>
          <p:nvPr/>
        </p:nvSpPr>
        <p:spPr>
          <a:xfrm>
            <a:off x="4573508" y="3312575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5" name="Freeform 225"/>
          <p:cNvSpPr/>
          <p:nvPr/>
        </p:nvSpPr>
        <p:spPr>
          <a:xfrm>
            <a:off x="4573508" y="2235106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6" name="Freeform 226"/>
          <p:cNvSpPr/>
          <p:nvPr/>
        </p:nvSpPr>
        <p:spPr>
          <a:xfrm>
            <a:off x="5625957" y="4024282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7" name="Freeform 227"/>
          <p:cNvSpPr/>
          <p:nvPr/>
        </p:nvSpPr>
        <p:spPr>
          <a:xfrm>
            <a:off x="5625957" y="3394490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8" name="Freeform 228"/>
          <p:cNvSpPr/>
          <p:nvPr/>
        </p:nvSpPr>
        <p:spPr>
          <a:xfrm>
            <a:off x="5625957" y="2560100"/>
            <a:ext cx="121793" cy="0"/>
          </a:xfrm>
          <a:custGeom>
            <a:avLst/>
            <a:gdLst/>
            <a:ahLst/>
            <a:cxnLst/>
            <a:rect l="0" t="0" r="0" b="0"/>
            <a:pathLst>
              <a:path w="121793">
                <a:moveTo>
                  <a:pt x="0" y="0"/>
                </a:moveTo>
                <a:lnTo>
                  <a:pt x="121793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9" name="Freeform 229"/>
          <p:cNvSpPr/>
          <p:nvPr/>
        </p:nvSpPr>
        <p:spPr>
          <a:xfrm>
            <a:off x="6678406" y="4109626"/>
            <a:ext cx="121792" cy="0"/>
          </a:xfrm>
          <a:custGeom>
            <a:avLst/>
            <a:gdLst/>
            <a:ahLst/>
            <a:cxnLst/>
            <a:rect l="0" t="0" r="0" b="0"/>
            <a:pathLst>
              <a:path w="121792">
                <a:moveTo>
                  <a:pt x="0" y="0"/>
                </a:moveTo>
                <a:lnTo>
                  <a:pt x="121792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0" name="Freeform 230"/>
          <p:cNvSpPr/>
          <p:nvPr/>
        </p:nvSpPr>
        <p:spPr>
          <a:xfrm>
            <a:off x="6678406" y="3559843"/>
            <a:ext cx="121792" cy="0"/>
          </a:xfrm>
          <a:custGeom>
            <a:avLst/>
            <a:gdLst/>
            <a:ahLst/>
            <a:cxnLst/>
            <a:rect l="0" t="0" r="0" b="0"/>
            <a:pathLst>
              <a:path w="121792">
                <a:moveTo>
                  <a:pt x="0" y="0"/>
                </a:moveTo>
                <a:lnTo>
                  <a:pt x="121792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1" name="Freeform 231"/>
          <p:cNvSpPr/>
          <p:nvPr/>
        </p:nvSpPr>
        <p:spPr>
          <a:xfrm>
            <a:off x="6678406" y="2711356"/>
            <a:ext cx="121792" cy="0"/>
          </a:xfrm>
          <a:custGeom>
            <a:avLst/>
            <a:gdLst/>
            <a:ahLst/>
            <a:cxnLst/>
            <a:rect l="0" t="0" r="0" b="0"/>
            <a:pathLst>
              <a:path w="121792">
                <a:moveTo>
                  <a:pt x="0" y="0"/>
                </a:moveTo>
                <a:lnTo>
                  <a:pt x="121792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2" name="Freeform 232"/>
          <p:cNvSpPr/>
          <p:nvPr/>
        </p:nvSpPr>
        <p:spPr>
          <a:xfrm>
            <a:off x="1445497" y="4027457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148"/>
                </a:moveTo>
                <a:cubicBezTo>
                  <a:pt x="62866" y="19939"/>
                  <a:pt x="54483" y="8129"/>
                  <a:pt x="41910" y="4064"/>
                </a:cubicBezTo>
                <a:cubicBezTo>
                  <a:pt x="29338" y="0"/>
                  <a:pt x="15494" y="4445"/>
                  <a:pt x="7747" y="15113"/>
                </a:cubicBezTo>
                <a:cubicBezTo>
                  <a:pt x="0" y="25909"/>
                  <a:pt x="0" y="40260"/>
                  <a:pt x="7747" y="51055"/>
                </a:cubicBezTo>
                <a:cubicBezTo>
                  <a:pt x="15494" y="61723"/>
                  <a:pt x="29338" y="66168"/>
                  <a:pt x="41910" y="62104"/>
                </a:cubicBezTo>
                <a:cubicBezTo>
                  <a:pt x="54483" y="58039"/>
                  <a:pt x="62866" y="46229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3" name="Freeform 233"/>
          <p:cNvSpPr/>
          <p:nvPr/>
        </p:nvSpPr>
        <p:spPr>
          <a:xfrm>
            <a:off x="1445497" y="4027457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148"/>
                </a:moveTo>
                <a:cubicBezTo>
                  <a:pt x="62866" y="19939"/>
                  <a:pt x="54483" y="8129"/>
                  <a:pt x="41910" y="4064"/>
                </a:cubicBezTo>
                <a:cubicBezTo>
                  <a:pt x="29338" y="0"/>
                  <a:pt x="15494" y="4445"/>
                  <a:pt x="7747" y="15113"/>
                </a:cubicBezTo>
                <a:cubicBezTo>
                  <a:pt x="0" y="25909"/>
                  <a:pt x="0" y="40260"/>
                  <a:pt x="7747" y="51055"/>
                </a:cubicBezTo>
                <a:cubicBezTo>
                  <a:pt x="15494" y="61723"/>
                  <a:pt x="29338" y="66168"/>
                  <a:pt x="41910" y="62104"/>
                </a:cubicBezTo>
                <a:cubicBezTo>
                  <a:pt x="54483" y="58039"/>
                  <a:pt x="62866" y="46229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4" name="Freeform 234"/>
          <p:cNvSpPr/>
          <p:nvPr/>
        </p:nvSpPr>
        <p:spPr>
          <a:xfrm>
            <a:off x="1445497" y="4027457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148"/>
                </a:moveTo>
                <a:cubicBezTo>
                  <a:pt x="62866" y="19939"/>
                  <a:pt x="54483" y="8129"/>
                  <a:pt x="41910" y="4064"/>
                </a:cubicBezTo>
                <a:cubicBezTo>
                  <a:pt x="29338" y="0"/>
                  <a:pt x="15494" y="4445"/>
                  <a:pt x="7747" y="15113"/>
                </a:cubicBezTo>
                <a:cubicBezTo>
                  <a:pt x="0" y="25909"/>
                  <a:pt x="0" y="40260"/>
                  <a:pt x="7747" y="51055"/>
                </a:cubicBezTo>
                <a:cubicBezTo>
                  <a:pt x="15494" y="61723"/>
                  <a:pt x="29338" y="66168"/>
                  <a:pt x="41910" y="62104"/>
                </a:cubicBezTo>
                <a:cubicBezTo>
                  <a:pt x="54483" y="58039"/>
                  <a:pt x="62866" y="46229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5" name="Freeform 235"/>
          <p:cNvSpPr/>
          <p:nvPr/>
        </p:nvSpPr>
        <p:spPr>
          <a:xfrm>
            <a:off x="1445497" y="3283745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147"/>
                </a:moveTo>
                <a:cubicBezTo>
                  <a:pt x="62866" y="19940"/>
                  <a:pt x="54483" y="8129"/>
                  <a:pt x="41910" y="4065"/>
                </a:cubicBezTo>
                <a:cubicBezTo>
                  <a:pt x="29338" y="0"/>
                  <a:pt x="15494" y="4445"/>
                  <a:pt x="7747" y="15113"/>
                </a:cubicBezTo>
                <a:cubicBezTo>
                  <a:pt x="0" y="25908"/>
                  <a:pt x="0" y="40259"/>
                  <a:pt x="7747" y="51055"/>
                </a:cubicBezTo>
                <a:cubicBezTo>
                  <a:pt x="15494" y="61722"/>
                  <a:pt x="29338" y="66168"/>
                  <a:pt x="41910" y="62104"/>
                </a:cubicBezTo>
                <a:cubicBezTo>
                  <a:pt x="54483" y="58040"/>
                  <a:pt x="62866" y="46229"/>
                  <a:pt x="62866" y="33147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6" name="Freeform 236"/>
          <p:cNvSpPr/>
          <p:nvPr/>
        </p:nvSpPr>
        <p:spPr>
          <a:xfrm>
            <a:off x="1445497" y="3283745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147"/>
                </a:moveTo>
                <a:cubicBezTo>
                  <a:pt x="62866" y="19940"/>
                  <a:pt x="54483" y="8129"/>
                  <a:pt x="41910" y="4065"/>
                </a:cubicBezTo>
                <a:cubicBezTo>
                  <a:pt x="29338" y="0"/>
                  <a:pt x="15494" y="4445"/>
                  <a:pt x="7747" y="15113"/>
                </a:cubicBezTo>
                <a:cubicBezTo>
                  <a:pt x="0" y="25908"/>
                  <a:pt x="0" y="40259"/>
                  <a:pt x="7747" y="51055"/>
                </a:cubicBezTo>
                <a:cubicBezTo>
                  <a:pt x="15494" y="61722"/>
                  <a:pt x="29338" y="66168"/>
                  <a:pt x="41910" y="62104"/>
                </a:cubicBezTo>
                <a:cubicBezTo>
                  <a:pt x="54483" y="58040"/>
                  <a:pt x="62866" y="46229"/>
                  <a:pt x="62866" y="33147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7" name="Freeform 237"/>
          <p:cNvSpPr/>
          <p:nvPr/>
        </p:nvSpPr>
        <p:spPr>
          <a:xfrm>
            <a:off x="1445497" y="3283745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147"/>
                </a:moveTo>
                <a:cubicBezTo>
                  <a:pt x="62866" y="19940"/>
                  <a:pt x="54483" y="8129"/>
                  <a:pt x="41910" y="4065"/>
                </a:cubicBezTo>
                <a:cubicBezTo>
                  <a:pt x="29338" y="0"/>
                  <a:pt x="15494" y="4445"/>
                  <a:pt x="7747" y="15113"/>
                </a:cubicBezTo>
                <a:cubicBezTo>
                  <a:pt x="0" y="25908"/>
                  <a:pt x="0" y="40259"/>
                  <a:pt x="7747" y="51055"/>
                </a:cubicBezTo>
                <a:cubicBezTo>
                  <a:pt x="15494" y="61722"/>
                  <a:pt x="29338" y="66168"/>
                  <a:pt x="41910" y="62104"/>
                </a:cubicBezTo>
                <a:cubicBezTo>
                  <a:pt x="54483" y="58040"/>
                  <a:pt x="62866" y="46229"/>
                  <a:pt x="62866" y="33147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8" name="Freeform 238"/>
          <p:cNvSpPr/>
          <p:nvPr/>
        </p:nvSpPr>
        <p:spPr>
          <a:xfrm>
            <a:off x="1445497" y="2125505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021"/>
                </a:moveTo>
                <a:cubicBezTo>
                  <a:pt x="62866" y="19939"/>
                  <a:pt x="54483" y="8128"/>
                  <a:pt x="41910" y="4064"/>
                </a:cubicBezTo>
                <a:cubicBezTo>
                  <a:pt x="29338" y="0"/>
                  <a:pt x="15494" y="4446"/>
                  <a:pt x="7747" y="15113"/>
                </a:cubicBezTo>
                <a:cubicBezTo>
                  <a:pt x="0" y="25909"/>
                  <a:pt x="0" y="40260"/>
                  <a:pt x="7747" y="51055"/>
                </a:cubicBezTo>
                <a:cubicBezTo>
                  <a:pt x="15494" y="61723"/>
                  <a:pt x="29338" y="66168"/>
                  <a:pt x="41910" y="62103"/>
                </a:cubicBezTo>
                <a:cubicBezTo>
                  <a:pt x="54483" y="58039"/>
                  <a:pt x="62866" y="46228"/>
                  <a:pt x="62866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9" name="Freeform 239"/>
          <p:cNvSpPr/>
          <p:nvPr/>
        </p:nvSpPr>
        <p:spPr>
          <a:xfrm>
            <a:off x="1445497" y="2125505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021"/>
                </a:moveTo>
                <a:cubicBezTo>
                  <a:pt x="62866" y="19939"/>
                  <a:pt x="54483" y="8128"/>
                  <a:pt x="41910" y="4064"/>
                </a:cubicBezTo>
                <a:cubicBezTo>
                  <a:pt x="29338" y="0"/>
                  <a:pt x="15494" y="4446"/>
                  <a:pt x="7747" y="15113"/>
                </a:cubicBezTo>
                <a:cubicBezTo>
                  <a:pt x="0" y="25909"/>
                  <a:pt x="0" y="40260"/>
                  <a:pt x="7747" y="51055"/>
                </a:cubicBezTo>
                <a:cubicBezTo>
                  <a:pt x="15494" y="61723"/>
                  <a:pt x="29338" y="66168"/>
                  <a:pt x="41910" y="62103"/>
                </a:cubicBezTo>
                <a:cubicBezTo>
                  <a:pt x="54483" y="58039"/>
                  <a:pt x="62866" y="46228"/>
                  <a:pt x="62866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0" name="Freeform 240"/>
          <p:cNvSpPr/>
          <p:nvPr/>
        </p:nvSpPr>
        <p:spPr>
          <a:xfrm>
            <a:off x="1445497" y="2125505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021"/>
                </a:moveTo>
                <a:cubicBezTo>
                  <a:pt x="62866" y="19939"/>
                  <a:pt x="54483" y="8128"/>
                  <a:pt x="41910" y="4064"/>
                </a:cubicBezTo>
                <a:cubicBezTo>
                  <a:pt x="29338" y="0"/>
                  <a:pt x="15494" y="4446"/>
                  <a:pt x="7747" y="15113"/>
                </a:cubicBezTo>
                <a:cubicBezTo>
                  <a:pt x="0" y="25909"/>
                  <a:pt x="0" y="40260"/>
                  <a:pt x="7747" y="51055"/>
                </a:cubicBezTo>
                <a:cubicBezTo>
                  <a:pt x="15494" y="61723"/>
                  <a:pt x="29338" y="66168"/>
                  <a:pt x="41910" y="62103"/>
                </a:cubicBezTo>
                <a:cubicBezTo>
                  <a:pt x="54483" y="58039"/>
                  <a:pt x="62866" y="46228"/>
                  <a:pt x="62866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1" name="Freeform 241"/>
          <p:cNvSpPr/>
          <p:nvPr/>
        </p:nvSpPr>
        <p:spPr>
          <a:xfrm>
            <a:off x="2494009" y="4045745"/>
            <a:ext cx="62866" cy="66167"/>
          </a:xfrm>
          <a:custGeom>
            <a:avLst/>
            <a:gdLst/>
            <a:ahLst/>
            <a:cxnLst/>
            <a:rect l="0" t="0" r="0" b="0"/>
            <a:pathLst>
              <a:path w="62866" h="66167">
                <a:moveTo>
                  <a:pt x="62866" y="33148"/>
                </a:moveTo>
                <a:cubicBezTo>
                  <a:pt x="62866" y="19940"/>
                  <a:pt x="54484" y="8129"/>
                  <a:pt x="41910" y="4065"/>
                </a:cubicBezTo>
                <a:cubicBezTo>
                  <a:pt x="29338" y="0"/>
                  <a:pt x="15494" y="4446"/>
                  <a:pt x="7747" y="15113"/>
                </a:cubicBezTo>
                <a:cubicBezTo>
                  <a:pt x="0" y="25909"/>
                  <a:pt x="0" y="40260"/>
                  <a:pt x="7747" y="51055"/>
                </a:cubicBezTo>
                <a:cubicBezTo>
                  <a:pt x="15494" y="61723"/>
                  <a:pt x="29338" y="66167"/>
                  <a:pt x="41910" y="62104"/>
                </a:cubicBezTo>
                <a:cubicBezTo>
                  <a:pt x="54484" y="58040"/>
                  <a:pt x="62866" y="46229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2" name="Freeform 242"/>
          <p:cNvSpPr/>
          <p:nvPr/>
        </p:nvSpPr>
        <p:spPr>
          <a:xfrm>
            <a:off x="2494009" y="4045745"/>
            <a:ext cx="62866" cy="66167"/>
          </a:xfrm>
          <a:custGeom>
            <a:avLst/>
            <a:gdLst/>
            <a:ahLst/>
            <a:cxnLst/>
            <a:rect l="0" t="0" r="0" b="0"/>
            <a:pathLst>
              <a:path w="62866" h="66167">
                <a:moveTo>
                  <a:pt x="62866" y="33148"/>
                </a:moveTo>
                <a:cubicBezTo>
                  <a:pt x="62866" y="19940"/>
                  <a:pt x="54484" y="8129"/>
                  <a:pt x="41910" y="4065"/>
                </a:cubicBezTo>
                <a:cubicBezTo>
                  <a:pt x="29338" y="0"/>
                  <a:pt x="15494" y="4446"/>
                  <a:pt x="7747" y="15113"/>
                </a:cubicBezTo>
                <a:cubicBezTo>
                  <a:pt x="0" y="25909"/>
                  <a:pt x="0" y="40260"/>
                  <a:pt x="7747" y="51055"/>
                </a:cubicBezTo>
                <a:cubicBezTo>
                  <a:pt x="15494" y="61723"/>
                  <a:pt x="29338" y="66167"/>
                  <a:pt x="41910" y="62104"/>
                </a:cubicBezTo>
                <a:cubicBezTo>
                  <a:pt x="54484" y="58040"/>
                  <a:pt x="62866" y="46229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3" name="Freeform 243"/>
          <p:cNvSpPr/>
          <p:nvPr/>
        </p:nvSpPr>
        <p:spPr>
          <a:xfrm>
            <a:off x="2494009" y="4045745"/>
            <a:ext cx="62866" cy="66167"/>
          </a:xfrm>
          <a:custGeom>
            <a:avLst/>
            <a:gdLst/>
            <a:ahLst/>
            <a:cxnLst/>
            <a:rect l="0" t="0" r="0" b="0"/>
            <a:pathLst>
              <a:path w="62866" h="66167">
                <a:moveTo>
                  <a:pt x="62866" y="33148"/>
                </a:moveTo>
                <a:cubicBezTo>
                  <a:pt x="62866" y="19940"/>
                  <a:pt x="54484" y="8129"/>
                  <a:pt x="41910" y="4065"/>
                </a:cubicBezTo>
                <a:cubicBezTo>
                  <a:pt x="29338" y="0"/>
                  <a:pt x="15494" y="4446"/>
                  <a:pt x="7747" y="15113"/>
                </a:cubicBezTo>
                <a:cubicBezTo>
                  <a:pt x="0" y="25909"/>
                  <a:pt x="0" y="40260"/>
                  <a:pt x="7747" y="51055"/>
                </a:cubicBezTo>
                <a:cubicBezTo>
                  <a:pt x="15494" y="61723"/>
                  <a:pt x="29338" y="66167"/>
                  <a:pt x="41910" y="62104"/>
                </a:cubicBezTo>
                <a:cubicBezTo>
                  <a:pt x="54484" y="58040"/>
                  <a:pt x="62866" y="46229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4" name="Freeform 244"/>
          <p:cNvSpPr/>
          <p:nvPr/>
        </p:nvSpPr>
        <p:spPr>
          <a:xfrm>
            <a:off x="2494009" y="3302033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020"/>
                </a:moveTo>
                <a:cubicBezTo>
                  <a:pt x="62866" y="19940"/>
                  <a:pt x="54484" y="8129"/>
                  <a:pt x="41910" y="4065"/>
                </a:cubicBezTo>
                <a:cubicBezTo>
                  <a:pt x="29338" y="0"/>
                  <a:pt x="15494" y="4445"/>
                  <a:pt x="7747" y="15113"/>
                </a:cubicBezTo>
                <a:cubicBezTo>
                  <a:pt x="0" y="25908"/>
                  <a:pt x="0" y="40259"/>
                  <a:pt x="7747" y="51055"/>
                </a:cubicBezTo>
                <a:cubicBezTo>
                  <a:pt x="15494" y="61722"/>
                  <a:pt x="29338" y="66168"/>
                  <a:pt x="41910" y="62104"/>
                </a:cubicBezTo>
                <a:cubicBezTo>
                  <a:pt x="54484" y="58040"/>
                  <a:pt x="62866" y="46229"/>
                  <a:pt x="62866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5" name="Freeform 245"/>
          <p:cNvSpPr/>
          <p:nvPr/>
        </p:nvSpPr>
        <p:spPr>
          <a:xfrm>
            <a:off x="2494009" y="3302033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020"/>
                </a:moveTo>
                <a:cubicBezTo>
                  <a:pt x="62866" y="19940"/>
                  <a:pt x="54484" y="8129"/>
                  <a:pt x="41910" y="4065"/>
                </a:cubicBezTo>
                <a:cubicBezTo>
                  <a:pt x="29338" y="0"/>
                  <a:pt x="15494" y="4445"/>
                  <a:pt x="7747" y="15113"/>
                </a:cubicBezTo>
                <a:cubicBezTo>
                  <a:pt x="0" y="25908"/>
                  <a:pt x="0" y="40259"/>
                  <a:pt x="7747" y="51055"/>
                </a:cubicBezTo>
                <a:cubicBezTo>
                  <a:pt x="15494" y="61722"/>
                  <a:pt x="29338" y="66168"/>
                  <a:pt x="41910" y="62104"/>
                </a:cubicBezTo>
                <a:cubicBezTo>
                  <a:pt x="54484" y="58040"/>
                  <a:pt x="62866" y="46229"/>
                  <a:pt x="62866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6" name="Freeform 246"/>
          <p:cNvSpPr/>
          <p:nvPr/>
        </p:nvSpPr>
        <p:spPr>
          <a:xfrm>
            <a:off x="2494009" y="3302033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020"/>
                </a:moveTo>
                <a:cubicBezTo>
                  <a:pt x="62866" y="19940"/>
                  <a:pt x="54484" y="8129"/>
                  <a:pt x="41910" y="4065"/>
                </a:cubicBezTo>
                <a:cubicBezTo>
                  <a:pt x="29338" y="0"/>
                  <a:pt x="15494" y="4445"/>
                  <a:pt x="7747" y="15113"/>
                </a:cubicBezTo>
                <a:cubicBezTo>
                  <a:pt x="0" y="25908"/>
                  <a:pt x="0" y="40259"/>
                  <a:pt x="7747" y="51055"/>
                </a:cubicBezTo>
                <a:cubicBezTo>
                  <a:pt x="15494" y="61722"/>
                  <a:pt x="29338" y="66168"/>
                  <a:pt x="41910" y="62104"/>
                </a:cubicBezTo>
                <a:cubicBezTo>
                  <a:pt x="54484" y="58040"/>
                  <a:pt x="62866" y="46229"/>
                  <a:pt x="62866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7" name="Freeform 247"/>
          <p:cNvSpPr/>
          <p:nvPr/>
        </p:nvSpPr>
        <p:spPr>
          <a:xfrm>
            <a:off x="2494009" y="2046257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021"/>
                </a:moveTo>
                <a:cubicBezTo>
                  <a:pt x="62866" y="19939"/>
                  <a:pt x="54484" y="8129"/>
                  <a:pt x="41910" y="4064"/>
                </a:cubicBezTo>
                <a:cubicBezTo>
                  <a:pt x="29338" y="0"/>
                  <a:pt x="15494" y="4446"/>
                  <a:pt x="7747" y="15113"/>
                </a:cubicBezTo>
                <a:cubicBezTo>
                  <a:pt x="0" y="25908"/>
                  <a:pt x="0" y="40259"/>
                  <a:pt x="7747" y="51055"/>
                </a:cubicBezTo>
                <a:cubicBezTo>
                  <a:pt x="15494" y="61722"/>
                  <a:pt x="29338" y="66168"/>
                  <a:pt x="41910" y="62104"/>
                </a:cubicBezTo>
                <a:cubicBezTo>
                  <a:pt x="54484" y="58039"/>
                  <a:pt x="62866" y="46229"/>
                  <a:pt x="62866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8" name="Freeform 248"/>
          <p:cNvSpPr/>
          <p:nvPr/>
        </p:nvSpPr>
        <p:spPr>
          <a:xfrm>
            <a:off x="2494009" y="2046257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021"/>
                </a:moveTo>
                <a:cubicBezTo>
                  <a:pt x="62866" y="19939"/>
                  <a:pt x="54484" y="8129"/>
                  <a:pt x="41910" y="4064"/>
                </a:cubicBezTo>
                <a:cubicBezTo>
                  <a:pt x="29338" y="0"/>
                  <a:pt x="15494" y="4446"/>
                  <a:pt x="7747" y="15113"/>
                </a:cubicBezTo>
                <a:cubicBezTo>
                  <a:pt x="0" y="25908"/>
                  <a:pt x="0" y="40259"/>
                  <a:pt x="7747" y="51055"/>
                </a:cubicBezTo>
                <a:cubicBezTo>
                  <a:pt x="15494" y="61722"/>
                  <a:pt x="29338" y="66168"/>
                  <a:pt x="41910" y="62104"/>
                </a:cubicBezTo>
                <a:cubicBezTo>
                  <a:pt x="54484" y="58039"/>
                  <a:pt x="62866" y="46229"/>
                  <a:pt x="62866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9" name="Freeform 249"/>
          <p:cNvSpPr/>
          <p:nvPr/>
        </p:nvSpPr>
        <p:spPr>
          <a:xfrm>
            <a:off x="2494009" y="2046257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021"/>
                </a:moveTo>
                <a:cubicBezTo>
                  <a:pt x="62866" y="19939"/>
                  <a:pt x="54484" y="8129"/>
                  <a:pt x="41910" y="4064"/>
                </a:cubicBezTo>
                <a:cubicBezTo>
                  <a:pt x="29338" y="0"/>
                  <a:pt x="15494" y="4446"/>
                  <a:pt x="7747" y="15113"/>
                </a:cubicBezTo>
                <a:cubicBezTo>
                  <a:pt x="0" y="25908"/>
                  <a:pt x="0" y="40259"/>
                  <a:pt x="7747" y="51055"/>
                </a:cubicBezTo>
                <a:cubicBezTo>
                  <a:pt x="15494" y="61722"/>
                  <a:pt x="29338" y="66168"/>
                  <a:pt x="41910" y="62104"/>
                </a:cubicBezTo>
                <a:cubicBezTo>
                  <a:pt x="54484" y="58039"/>
                  <a:pt x="62866" y="46229"/>
                  <a:pt x="62866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0" name="Freeform 250"/>
          <p:cNvSpPr/>
          <p:nvPr/>
        </p:nvSpPr>
        <p:spPr>
          <a:xfrm>
            <a:off x="3548618" y="4033554"/>
            <a:ext cx="62865" cy="66166"/>
          </a:xfrm>
          <a:custGeom>
            <a:avLst/>
            <a:gdLst/>
            <a:ahLst/>
            <a:cxnLst/>
            <a:rect l="0" t="0" r="0" b="0"/>
            <a:pathLst>
              <a:path w="62865" h="66166">
                <a:moveTo>
                  <a:pt x="62865" y="33020"/>
                </a:moveTo>
                <a:cubicBezTo>
                  <a:pt x="62865" y="19939"/>
                  <a:pt x="54483" y="8127"/>
                  <a:pt x="41909" y="4064"/>
                </a:cubicBezTo>
                <a:cubicBezTo>
                  <a:pt x="29337" y="0"/>
                  <a:pt x="15494" y="4445"/>
                  <a:pt x="7746" y="15113"/>
                </a:cubicBezTo>
                <a:cubicBezTo>
                  <a:pt x="0" y="25908"/>
                  <a:pt x="0" y="40258"/>
                  <a:pt x="7746" y="51053"/>
                </a:cubicBezTo>
                <a:cubicBezTo>
                  <a:pt x="15494" y="61721"/>
                  <a:pt x="29337" y="66166"/>
                  <a:pt x="41909" y="62102"/>
                </a:cubicBezTo>
                <a:cubicBezTo>
                  <a:pt x="54483" y="58039"/>
                  <a:pt x="62865" y="46227"/>
                  <a:pt x="62865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1" name="Freeform 251"/>
          <p:cNvSpPr/>
          <p:nvPr/>
        </p:nvSpPr>
        <p:spPr>
          <a:xfrm>
            <a:off x="3548618" y="4033554"/>
            <a:ext cx="62865" cy="66166"/>
          </a:xfrm>
          <a:custGeom>
            <a:avLst/>
            <a:gdLst/>
            <a:ahLst/>
            <a:cxnLst/>
            <a:rect l="0" t="0" r="0" b="0"/>
            <a:pathLst>
              <a:path w="62865" h="66166">
                <a:moveTo>
                  <a:pt x="62865" y="33020"/>
                </a:moveTo>
                <a:cubicBezTo>
                  <a:pt x="62865" y="19939"/>
                  <a:pt x="54483" y="8127"/>
                  <a:pt x="41909" y="4064"/>
                </a:cubicBezTo>
                <a:cubicBezTo>
                  <a:pt x="29337" y="0"/>
                  <a:pt x="15494" y="4445"/>
                  <a:pt x="7746" y="15113"/>
                </a:cubicBezTo>
                <a:cubicBezTo>
                  <a:pt x="0" y="25908"/>
                  <a:pt x="0" y="40258"/>
                  <a:pt x="7746" y="51053"/>
                </a:cubicBezTo>
                <a:cubicBezTo>
                  <a:pt x="15494" y="61721"/>
                  <a:pt x="29337" y="66166"/>
                  <a:pt x="41909" y="62102"/>
                </a:cubicBezTo>
                <a:cubicBezTo>
                  <a:pt x="54483" y="58039"/>
                  <a:pt x="62865" y="46227"/>
                  <a:pt x="62865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2" name="Freeform 252"/>
          <p:cNvSpPr/>
          <p:nvPr/>
        </p:nvSpPr>
        <p:spPr>
          <a:xfrm>
            <a:off x="3548618" y="4033554"/>
            <a:ext cx="62865" cy="66166"/>
          </a:xfrm>
          <a:custGeom>
            <a:avLst/>
            <a:gdLst/>
            <a:ahLst/>
            <a:cxnLst/>
            <a:rect l="0" t="0" r="0" b="0"/>
            <a:pathLst>
              <a:path w="62865" h="66166">
                <a:moveTo>
                  <a:pt x="62865" y="33020"/>
                </a:moveTo>
                <a:cubicBezTo>
                  <a:pt x="62865" y="19939"/>
                  <a:pt x="54483" y="8127"/>
                  <a:pt x="41909" y="4064"/>
                </a:cubicBezTo>
                <a:cubicBezTo>
                  <a:pt x="29337" y="0"/>
                  <a:pt x="15494" y="4445"/>
                  <a:pt x="7746" y="15113"/>
                </a:cubicBezTo>
                <a:cubicBezTo>
                  <a:pt x="0" y="25908"/>
                  <a:pt x="0" y="40258"/>
                  <a:pt x="7746" y="51053"/>
                </a:cubicBezTo>
                <a:cubicBezTo>
                  <a:pt x="15494" y="61721"/>
                  <a:pt x="29337" y="66166"/>
                  <a:pt x="41909" y="62102"/>
                </a:cubicBezTo>
                <a:cubicBezTo>
                  <a:pt x="54483" y="58039"/>
                  <a:pt x="62865" y="46227"/>
                  <a:pt x="62865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3" name="Freeform 253"/>
          <p:cNvSpPr/>
          <p:nvPr/>
        </p:nvSpPr>
        <p:spPr>
          <a:xfrm>
            <a:off x="3548618" y="3308129"/>
            <a:ext cx="62865" cy="66167"/>
          </a:xfrm>
          <a:custGeom>
            <a:avLst/>
            <a:gdLst/>
            <a:ahLst/>
            <a:cxnLst/>
            <a:rect l="0" t="0" r="0" b="0"/>
            <a:pathLst>
              <a:path w="62865" h="66167">
                <a:moveTo>
                  <a:pt x="62865" y="33021"/>
                </a:moveTo>
                <a:cubicBezTo>
                  <a:pt x="62865" y="19939"/>
                  <a:pt x="54483" y="8128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9"/>
                  <a:pt x="0" y="40260"/>
                  <a:pt x="7746" y="51054"/>
                </a:cubicBezTo>
                <a:cubicBezTo>
                  <a:pt x="15494" y="61723"/>
                  <a:pt x="29337" y="66167"/>
                  <a:pt x="41909" y="62103"/>
                </a:cubicBezTo>
                <a:cubicBezTo>
                  <a:pt x="54483" y="58039"/>
                  <a:pt x="62865" y="46228"/>
                  <a:pt x="62865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4" name="Freeform 254"/>
          <p:cNvSpPr/>
          <p:nvPr/>
        </p:nvSpPr>
        <p:spPr>
          <a:xfrm>
            <a:off x="3548618" y="3308129"/>
            <a:ext cx="62865" cy="66167"/>
          </a:xfrm>
          <a:custGeom>
            <a:avLst/>
            <a:gdLst/>
            <a:ahLst/>
            <a:cxnLst/>
            <a:rect l="0" t="0" r="0" b="0"/>
            <a:pathLst>
              <a:path w="62865" h="66167">
                <a:moveTo>
                  <a:pt x="62865" y="33021"/>
                </a:moveTo>
                <a:cubicBezTo>
                  <a:pt x="62865" y="19939"/>
                  <a:pt x="54483" y="8128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9"/>
                  <a:pt x="0" y="40260"/>
                  <a:pt x="7746" y="51054"/>
                </a:cubicBezTo>
                <a:cubicBezTo>
                  <a:pt x="15494" y="61723"/>
                  <a:pt x="29337" y="66167"/>
                  <a:pt x="41909" y="62103"/>
                </a:cubicBezTo>
                <a:cubicBezTo>
                  <a:pt x="54483" y="58039"/>
                  <a:pt x="62865" y="46228"/>
                  <a:pt x="62865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5" name="Freeform 255"/>
          <p:cNvSpPr/>
          <p:nvPr/>
        </p:nvSpPr>
        <p:spPr>
          <a:xfrm>
            <a:off x="3548618" y="3308129"/>
            <a:ext cx="62865" cy="66167"/>
          </a:xfrm>
          <a:custGeom>
            <a:avLst/>
            <a:gdLst/>
            <a:ahLst/>
            <a:cxnLst/>
            <a:rect l="0" t="0" r="0" b="0"/>
            <a:pathLst>
              <a:path w="62865" h="66167">
                <a:moveTo>
                  <a:pt x="62865" y="33021"/>
                </a:moveTo>
                <a:cubicBezTo>
                  <a:pt x="62865" y="19939"/>
                  <a:pt x="54483" y="8128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9"/>
                  <a:pt x="0" y="40260"/>
                  <a:pt x="7746" y="51054"/>
                </a:cubicBezTo>
                <a:cubicBezTo>
                  <a:pt x="15494" y="61723"/>
                  <a:pt x="29337" y="66167"/>
                  <a:pt x="41909" y="62103"/>
                </a:cubicBezTo>
                <a:cubicBezTo>
                  <a:pt x="54483" y="58039"/>
                  <a:pt x="62865" y="46228"/>
                  <a:pt x="62865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6" name="Freeform 256"/>
          <p:cNvSpPr/>
          <p:nvPr/>
        </p:nvSpPr>
        <p:spPr>
          <a:xfrm>
            <a:off x="3548618" y="2082833"/>
            <a:ext cx="62865" cy="66168"/>
          </a:xfrm>
          <a:custGeom>
            <a:avLst/>
            <a:gdLst/>
            <a:ahLst/>
            <a:cxnLst/>
            <a:rect l="0" t="0" r="0" b="0"/>
            <a:pathLst>
              <a:path w="62865" h="66168">
                <a:moveTo>
                  <a:pt x="62865" y="33020"/>
                </a:moveTo>
                <a:cubicBezTo>
                  <a:pt x="62865" y="19940"/>
                  <a:pt x="54483" y="8129"/>
                  <a:pt x="41909" y="4065"/>
                </a:cubicBezTo>
                <a:cubicBezTo>
                  <a:pt x="29337" y="0"/>
                  <a:pt x="15494" y="4445"/>
                  <a:pt x="7746" y="15113"/>
                </a:cubicBezTo>
                <a:cubicBezTo>
                  <a:pt x="0" y="25908"/>
                  <a:pt x="0" y="40259"/>
                  <a:pt x="7746" y="51055"/>
                </a:cubicBezTo>
                <a:cubicBezTo>
                  <a:pt x="15494" y="61722"/>
                  <a:pt x="29337" y="66168"/>
                  <a:pt x="41909" y="62104"/>
                </a:cubicBezTo>
                <a:cubicBezTo>
                  <a:pt x="54483" y="58040"/>
                  <a:pt x="62865" y="46229"/>
                  <a:pt x="62865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7" name="Freeform 257"/>
          <p:cNvSpPr/>
          <p:nvPr/>
        </p:nvSpPr>
        <p:spPr>
          <a:xfrm>
            <a:off x="3548618" y="2082833"/>
            <a:ext cx="62865" cy="66168"/>
          </a:xfrm>
          <a:custGeom>
            <a:avLst/>
            <a:gdLst/>
            <a:ahLst/>
            <a:cxnLst/>
            <a:rect l="0" t="0" r="0" b="0"/>
            <a:pathLst>
              <a:path w="62865" h="66168">
                <a:moveTo>
                  <a:pt x="62865" y="33020"/>
                </a:moveTo>
                <a:cubicBezTo>
                  <a:pt x="62865" y="19940"/>
                  <a:pt x="54483" y="8129"/>
                  <a:pt x="41909" y="4065"/>
                </a:cubicBezTo>
                <a:cubicBezTo>
                  <a:pt x="29337" y="0"/>
                  <a:pt x="15494" y="4445"/>
                  <a:pt x="7746" y="15113"/>
                </a:cubicBezTo>
                <a:cubicBezTo>
                  <a:pt x="0" y="25908"/>
                  <a:pt x="0" y="40259"/>
                  <a:pt x="7746" y="51055"/>
                </a:cubicBezTo>
                <a:cubicBezTo>
                  <a:pt x="15494" y="61722"/>
                  <a:pt x="29337" y="66168"/>
                  <a:pt x="41909" y="62104"/>
                </a:cubicBezTo>
                <a:cubicBezTo>
                  <a:pt x="54483" y="58040"/>
                  <a:pt x="62865" y="46229"/>
                  <a:pt x="62865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8" name="Freeform 258"/>
          <p:cNvSpPr/>
          <p:nvPr/>
        </p:nvSpPr>
        <p:spPr>
          <a:xfrm>
            <a:off x="3548618" y="2082833"/>
            <a:ext cx="62865" cy="66168"/>
          </a:xfrm>
          <a:custGeom>
            <a:avLst/>
            <a:gdLst/>
            <a:ahLst/>
            <a:cxnLst/>
            <a:rect l="0" t="0" r="0" b="0"/>
            <a:pathLst>
              <a:path w="62865" h="66168">
                <a:moveTo>
                  <a:pt x="62865" y="33020"/>
                </a:moveTo>
                <a:cubicBezTo>
                  <a:pt x="62865" y="19940"/>
                  <a:pt x="54483" y="8129"/>
                  <a:pt x="41909" y="4065"/>
                </a:cubicBezTo>
                <a:cubicBezTo>
                  <a:pt x="29337" y="0"/>
                  <a:pt x="15494" y="4445"/>
                  <a:pt x="7746" y="15113"/>
                </a:cubicBezTo>
                <a:cubicBezTo>
                  <a:pt x="0" y="25908"/>
                  <a:pt x="0" y="40259"/>
                  <a:pt x="7746" y="51055"/>
                </a:cubicBezTo>
                <a:cubicBezTo>
                  <a:pt x="15494" y="61722"/>
                  <a:pt x="29337" y="66168"/>
                  <a:pt x="41909" y="62104"/>
                </a:cubicBezTo>
                <a:cubicBezTo>
                  <a:pt x="54483" y="58040"/>
                  <a:pt x="62865" y="46229"/>
                  <a:pt x="62865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9" name="Freeform 259"/>
          <p:cNvSpPr/>
          <p:nvPr/>
        </p:nvSpPr>
        <p:spPr>
          <a:xfrm>
            <a:off x="4603226" y="4021362"/>
            <a:ext cx="62864" cy="66167"/>
          </a:xfrm>
          <a:custGeom>
            <a:avLst/>
            <a:gdLst/>
            <a:ahLst/>
            <a:cxnLst/>
            <a:rect l="0" t="0" r="0" b="0"/>
            <a:pathLst>
              <a:path w="62864" h="66167">
                <a:moveTo>
                  <a:pt x="62864" y="33146"/>
                </a:moveTo>
                <a:cubicBezTo>
                  <a:pt x="62864" y="19938"/>
                  <a:pt x="54482" y="8127"/>
                  <a:pt x="41909" y="4063"/>
                </a:cubicBezTo>
                <a:cubicBezTo>
                  <a:pt x="29337" y="0"/>
                  <a:pt x="15494" y="4444"/>
                  <a:pt x="7746" y="15113"/>
                </a:cubicBezTo>
                <a:cubicBezTo>
                  <a:pt x="0" y="25907"/>
                  <a:pt x="0" y="40258"/>
                  <a:pt x="7746" y="51054"/>
                </a:cubicBezTo>
                <a:cubicBezTo>
                  <a:pt x="15494" y="61721"/>
                  <a:pt x="29337" y="66167"/>
                  <a:pt x="41909" y="62102"/>
                </a:cubicBezTo>
                <a:cubicBezTo>
                  <a:pt x="54482" y="58038"/>
                  <a:pt x="62864" y="46227"/>
                  <a:pt x="62864" y="33146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0" name="Freeform 260"/>
          <p:cNvSpPr/>
          <p:nvPr/>
        </p:nvSpPr>
        <p:spPr>
          <a:xfrm>
            <a:off x="4603226" y="4021362"/>
            <a:ext cx="62864" cy="66167"/>
          </a:xfrm>
          <a:custGeom>
            <a:avLst/>
            <a:gdLst/>
            <a:ahLst/>
            <a:cxnLst/>
            <a:rect l="0" t="0" r="0" b="0"/>
            <a:pathLst>
              <a:path w="62864" h="66167">
                <a:moveTo>
                  <a:pt x="62864" y="33146"/>
                </a:moveTo>
                <a:cubicBezTo>
                  <a:pt x="62864" y="19938"/>
                  <a:pt x="54482" y="8127"/>
                  <a:pt x="41909" y="4063"/>
                </a:cubicBezTo>
                <a:cubicBezTo>
                  <a:pt x="29337" y="0"/>
                  <a:pt x="15494" y="4444"/>
                  <a:pt x="7746" y="15113"/>
                </a:cubicBezTo>
                <a:cubicBezTo>
                  <a:pt x="0" y="25907"/>
                  <a:pt x="0" y="40258"/>
                  <a:pt x="7746" y="51054"/>
                </a:cubicBezTo>
                <a:cubicBezTo>
                  <a:pt x="15494" y="61721"/>
                  <a:pt x="29337" y="66167"/>
                  <a:pt x="41909" y="62102"/>
                </a:cubicBezTo>
                <a:cubicBezTo>
                  <a:pt x="54482" y="58038"/>
                  <a:pt x="62864" y="46227"/>
                  <a:pt x="62864" y="33146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1" name="Freeform 261"/>
          <p:cNvSpPr/>
          <p:nvPr/>
        </p:nvSpPr>
        <p:spPr>
          <a:xfrm>
            <a:off x="4603226" y="4021362"/>
            <a:ext cx="62864" cy="66167"/>
          </a:xfrm>
          <a:custGeom>
            <a:avLst/>
            <a:gdLst/>
            <a:ahLst/>
            <a:cxnLst/>
            <a:rect l="0" t="0" r="0" b="0"/>
            <a:pathLst>
              <a:path w="62864" h="66167">
                <a:moveTo>
                  <a:pt x="62864" y="33146"/>
                </a:moveTo>
                <a:cubicBezTo>
                  <a:pt x="62864" y="19938"/>
                  <a:pt x="54482" y="8127"/>
                  <a:pt x="41909" y="4063"/>
                </a:cubicBezTo>
                <a:cubicBezTo>
                  <a:pt x="29337" y="0"/>
                  <a:pt x="15494" y="4444"/>
                  <a:pt x="7746" y="15113"/>
                </a:cubicBezTo>
                <a:cubicBezTo>
                  <a:pt x="0" y="25907"/>
                  <a:pt x="0" y="40258"/>
                  <a:pt x="7746" y="51054"/>
                </a:cubicBezTo>
                <a:cubicBezTo>
                  <a:pt x="15494" y="61721"/>
                  <a:pt x="29337" y="66167"/>
                  <a:pt x="41909" y="62102"/>
                </a:cubicBezTo>
                <a:cubicBezTo>
                  <a:pt x="54482" y="58038"/>
                  <a:pt x="62864" y="46227"/>
                  <a:pt x="62864" y="33146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2" name="Freeform 262"/>
          <p:cNvSpPr/>
          <p:nvPr/>
        </p:nvSpPr>
        <p:spPr>
          <a:xfrm>
            <a:off x="4603226" y="3265457"/>
            <a:ext cx="62864" cy="66168"/>
          </a:xfrm>
          <a:custGeom>
            <a:avLst/>
            <a:gdLst/>
            <a:ahLst/>
            <a:cxnLst/>
            <a:rect l="0" t="0" r="0" b="0"/>
            <a:pathLst>
              <a:path w="62864" h="66168">
                <a:moveTo>
                  <a:pt x="62864" y="33021"/>
                </a:moveTo>
                <a:cubicBezTo>
                  <a:pt x="62864" y="19939"/>
                  <a:pt x="54482" y="8129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8"/>
                  <a:pt x="0" y="40259"/>
                  <a:pt x="7746" y="51055"/>
                </a:cubicBezTo>
                <a:cubicBezTo>
                  <a:pt x="15494" y="61722"/>
                  <a:pt x="29337" y="66168"/>
                  <a:pt x="41909" y="62104"/>
                </a:cubicBezTo>
                <a:cubicBezTo>
                  <a:pt x="54482" y="58039"/>
                  <a:pt x="62864" y="46229"/>
                  <a:pt x="62864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3" name="Freeform 263"/>
          <p:cNvSpPr/>
          <p:nvPr/>
        </p:nvSpPr>
        <p:spPr>
          <a:xfrm>
            <a:off x="4603226" y="3265457"/>
            <a:ext cx="62864" cy="66168"/>
          </a:xfrm>
          <a:custGeom>
            <a:avLst/>
            <a:gdLst/>
            <a:ahLst/>
            <a:cxnLst/>
            <a:rect l="0" t="0" r="0" b="0"/>
            <a:pathLst>
              <a:path w="62864" h="66168">
                <a:moveTo>
                  <a:pt x="62864" y="33021"/>
                </a:moveTo>
                <a:cubicBezTo>
                  <a:pt x="62864" y="19939"/>
                  <a:pt x="54482" y="8129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8"/>
                  <a:pt x="0" y="40259"/>
                  <a:pt x="7746" y="51055"/>
                </a:cubicBezTo>
                <a:cubicBezTo>
                  <a:pt x="15494" y="61722"/>
                  <a:pt x="29337" y="66168"/>
                  <a:pt x="41909" y="62104"/>
                </a:cubicBezTo>
                <a:cubicBezTo>
                  <a:pt x="54482" y="58039"/>
                  <a:pt x="62864" y="46229"/>
                  <a:pt x="62864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4" name="Freeform 264"/>
          <p:cNvSpPr/>
          <p:nvPr/>
        </p:nvSpPr>
        <p:spPr>
          <a:xfrm>
            <a:off x="4603226" y="3265457"/>
            <a:ext cx="62864" cy="66168"/>
          </a:xfrm>
          <a:custGeom>
            <a:avLst/>
            <a:gdLst/>
            <a:ahLst/>
            <a:cxnLst/>
            <a:rect l="0" t="0" r="0" b="0"/>
            <a:pathLst>
              <a:path w="62864" h="66168">
                <a:moveTo>
                  <a:pt x="62864" y="33021"/>
                </a:moveTo>
                <a:cubicBezTo>
                  <a:pt x="62864" y="19939"/>
                  <a:pt x="54482" y="8129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8"/>
                  <a:pt x="0" y="40259"/>
                  <a:pt x="7746" y="51055"/>
                </a:cubicBezTo>
                <a:cubicBezTo>
                  <a:pt x="15494" y="61722"/>
                  <a:pt x="29337" y="66168"/>
                  <a:pt x="41909" y="62104"/>
                </a:cubicBezTo>
                <a:cubicBezTo>
                  <a:pt x="54482" y="58039"/>
                  <a:pt x="62864" y="46229"/>
                  <a:pt x="62864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5" name="Freeform 265"/>
          <p:cNvSpPr/>
          <p:nvPr/>
        </p:nvSpPr>
        <p:spPr>
          <a:xfrm>
            <a:off x="4603226" y="2168178"/>
            <a:ext cx="62864" cy="66166"/>
          </a:xfrm>
          <a:custGeom>
            <a:avLst/>
            <a:gdLst/>
            <a:ahLst/>
            <a:cxnLst/>
            <a:rect l="0" t="0" r="0" b="0"/>
            <a:pathLst>
              <a:path w="62864" h="66166">
                <a:moveTo>
                  <a:pt x="62864" y="33020"/>
                </a:moveTo>
                <a:cubicBezTo>
                  <a:pt x="62864" y="19938"/>
                  <a:pt x="54482" y="8127"/>
                  <a:pt x="41909" y="4063"/>
                </a:cubicBezTo>
                <a:cubicBezTo>
                  <a:pt x="29337" y="0"/>
                  <a:pt x="15494" y="4445"/>
                  <a:pt x="7746" y="15112"/>
                </a:cubicBezTo>
                <a:cubicBezTo>
                  <a:pt x="0" y="25908"/>
                  <a:pt x="0" y="40259"/>
                  <a:pt x="7746" y="51053"/>
                </a:cubicBezTo>
                <a:cubicBezTo>
                  <a:pt x="15494" y="61722"/>
                  <a:pt x="29337" y="66166"/>
                  <a:pt x="41909" y="62102"/>
                </a:cubicBezTo>
                <a:cubicBezTo>
                  <a:pt x="54482" y="58038"/>
                  <a:pt x="62864" y="46227"/>
                  <a:pt x="62864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6" name="Freeform 266"/>
          <p:cNvSpPr/>
          <p:nvPr/>
        </p:nvSpPr>
        <p:spPr>
          <a:xfrm>
            <a:off x="4603226" y="2168178"/>
            <a:ext cx="62864" cy="66166"/>
          </a:xfrm>
          <a:custGeom>
            <a:avLst/>
            <a:gdLst/>
            <a:ahLst/>
            <a:cxnLst/>
            <a:rect l="0" t="0" r="0" b="0"/>
            <a:pathLst>
              <a:path w="62864" h="66166">
                <a:moveTo>
                  <a:pt x="62864" y="33020"/>
                </a:moveTo>
                <a:cubicBezTo>
                  <a:pt x="62864" y="19938"/>
                  <a:pt x="54482" y="8127"/>
                  <a:pt x="41909" y="4063"/>
                </a:cubicBezTo>
                <a:cubicBezTo>
                  <a:pt x="29337" y="0"/>
                  <a:pt x="15494" y="4445"/>
                  <a:pt x="7746" y="15112"/>
                </a:cubicBezTo>
                <a:cubicBezTo>
                  <a:pt x="0" y="25908"/>
                  <a:pt x="0" y="40259"/>
                  <a:pt x="7746" y="51053"/>
                </a:cubicBezTo>
                <a:cubicBezTo>
                  <a:pt x="15494" y="61722"/>
                  <a:pt x="29337" y="66166"/>
                  <a:pt x="41909" y="62102"/>
                </a:cubicBezTo>
                <a:cubicBezTo>
                  <a:pt x="54482" y="58038"/>
                  <a:pt x="62864" y="46227"/>
                  <a:pt x="62864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7" name="Freeform 267"/>
          <p:cNvSpPr/>
          <p:nvPr/>
        </p:nvSpPr>
        <p:spPr>
          <a:xfrm>
            <a:off x="4603226" y="2168178"/>
            <a:ext cx="62864" cy="66166"/>
          </a:xfrm>
          <a:custGeom>
            <a:avLst/>
            <a:gdLst/>
            <a:ahLst/>
            <a:cxnLst/>
            <a:rect l="0" t="0" r="0" b="0"/>
            <a:pathLst>
              <a:path w="62864" h="66166">
                <a:moveTo>
                  <a:pt x="62864" y="33020"/>
                </a:moveTo>
                <a:cubicBezTo>
                  <a:pt x="62864" y="19938"/>
                  <a:pt x="54482" y="8127"/>
                  <a:pt x="41909" y="4063"/>
                </a:cubicBezTo>
                <a:cubicBezTo>
                  <a:pt x="29337" y="0"/>
                  <a:pt x="15494" y="4445"/>
                  <a:pt x="7746" y="15112"/>
                </a:cubicBezTo>
                <a:cubicBezTo>
                  <a:pt x="0" y="25908"/>
                  <a:pt x="0" y="40259"/>
                  <a:pt x="7746" y="51053"/>
                </a:cubicBezTo>
                <a:cubicBezTo>
                  <a:pt x="15494" y="61722"/>
                  <a:pt x="29337" y="66166"/>
                  <a:pt x="41909" y="62102"/>
                </a:cubicBezTo>
                <a:cubicBezTo>
                  <a:pt x="54482" y="58038"/>
                  <a:pt x="62864" y="46227"/>
                  <a:pt x="62864" y="33020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8" name="Freeform 268"/>
          <p:cNvSpPr/>
          <p:nvPr/>
        </p:nvSpPr>
        <p:spPr>
          <a:xfrm>
            <a:off x="5651738" y="3972593"/>
            <a:ext cx="62992" cy="66168"/>
          </a:xfrm>
          <a:custGeom>
            <a:avLst/>
            <a:gdLst/>
            <a:ahLst/>
            <a:cxnLst/>
            <a:rect l="0" t="0" r="0" b="0"/>
            <a:pathLst>
              <a:path w="62992" h="66168">
                <a:moveTo>
                  <a:pt x="62992" y="33148"/>
                </a:moveTo>
                <a:cubicBezTo>
                  <a:pt x="62992" y="19939"/>
                  <a:pt x="54482" y="8128"/>
                  <a:pt x="41909" y="4064"/>
                </a:cubicBezTo>
                <a:cubicBezTo>
                  <a:pt x="29337" y="0"/>
                  <a:pt x="15494" y="4445"/>
                  <a:pt x="7746" y="15113"/>
                </a:cubicBezTo>
                <a:cubicBezTo>
                  <a:pt x="0" y="25908"/>
                  <a:pt x="0" y="40259"/>
                  <a:pt x="7746" y="51055"/>
                </a:cubicBezTo>
                <a:cubicBezTo>
                  <a:pt x="15494" y="61723"/>
                  <a:pt x="29337" y="66168"/>
                  <a:pt x="41909" y="62103"/>
                </a:cubicBezTo>
                <a:cubicBezTo>
                  <a:pt x="54482" y="58039"/>
                  <a:pt x="62992" y="46228"/>
                  <a:pt x="62992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9" name="Freeform 269"/>
          <p:cNvSpPr/>
          <p:nvPr/>
        </p:nvSpPr>
        <p:spPr>
          <a:xfrm>
            <a:off x="5651738" y="3972593"/>
            <a:ext cx="62992" cy="66168"/>
          </a:xfrm>
          <a:custGeom>
            <a:avLst/>
            <a:gdLst/>
            <a:ahLst/>
            <a:cxnLst/>
            <a:rect l="0" t="0" r="0" b="0"/>
            <a:pathLst>
              <a:path w="62992" h="66168">
                <a:moveTo>
                  <a:pt x="62992" y="33148"/>
                </a:moveTo>
                <a:cubicBezTo>
                  <a:pt x="62992" y="19939"/>
                  <a:pt x="54482" y="8128"/>
                  <a:pt x="41909" y="4064"/>
                </a:cubicBezTo>
                <a:cubicBezTo>
                  <a:pt x="29337" y="0"/>
                  <a:pt x="15494" y="4445"/>
                  <a:pt x="7746" y="15113"/>
                </a:cubicBezTo>
                <a:cubicBezTo>
                  <a:pt x="0" y="25908"/>
                  <a:pt x="0" y="40259"/>
                  <a:pt x="7746" y="51055"/>
                </a:cubicBezTo>
                <a:cubicBezTo>
                  <a:pt x="15494" y="61723"/>
                  <a:pt x="29337" y="66168"/>
                  <a:pt x="41909" y="62103"/>
                </a:cubicBezTo>
                <a:cubicBezTo>
                  <a:pt x="54482" y="58039"/>
                  <a:pt x="62992" y="46228"/>
                  <a:pt x="62992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0" name="Freeform 270"/>
          <p:cNvSpPr/>
          <p:nvPr/>
        </p:nvSpPr>
        <p:spPr>
          <a:xfrm>
            <a:off x="5651738" y="3972593"/>
            <a:ext cx="62992" cy="66168"/>
          </a:xfrm>
          <a:custGeom>
            <a:avLst/>
            <a:gdLst/>
            <a:ahLst/>
            <a:cxnLst/>
            <a:rect l="0" t="0" r="0" b="0"/>
            <a:pathLst>
              <a:path w="62992" h="66168">
                <a:moveTo>
                  <a:pt x="62992" y="33148"/>
                </a:moveTo>
                <a:cubicBezTo>
                  <a:pt x="62992" y="19939"/>
                  <a:pt x="54482" y="8128"/>
                  <a:pt x="41909" y="4064"/>
                </a:cubicBezTo>
                <a:cubicBezTo>
                  <a:pt x="29337" y="0"/>
                  <a:pt x="15494" y="4445"/>
                  <a:pt x="7746" y="15113"/>
                </a:cubicBezTo>
                <a:cubicBezTo>
                  <a:pt x="0" y="25908"/>
                  <a:pt x="0" y="40259"/>
                  <a:pt x="7746" y="51055"/>
                </a:cubicBezTo>
                <a:cubicBezTo>
                  <a:pt x="15494" y="61723"/>
                  <a:pt x="29337" y="66168"/>
                  <a:pt x="41909" y="62103"/>
                </a:cubicBezTo>
                <a:cubicBezTo>
                  <a:pt x="54482" y="58039"/>
                  <a:pt x="62992" y="46228"/>
                  <a:pt x="62992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1" name="Freeform 271"/>
          <p:cNvSpPr/>
          <p:nvPr/>
        </p:nvSpPr>
        <p:spPr>
          <a:xfrm>
            <a:off x="5651738" y="3344705"/>
            <a:ext cx="62992" cy="66168"/>
          </a:xfrm>
          <a:custGeom>
            <a:avLst/>
            <a:gdLst/>
            <a:ahLst/>
            <a:cxnLst/>
            <a:rect l="0" t="0" r="0" b="0"/>
            <a:pathLst>
              <a:path w="62992" h="66168">
                <a:moveTo>
                  <a:pt x="62992" y="33021"/>
                </a:moveTo>
                <a:cubicBezTo>
                  <a:pt x="62992" y="19939"/>
                  <a:pt x="54482" y="8128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9"/>
                  <a:pt x="0" y="40260"/>
                  <a:pt x="7746" y="51055"/>
                </a:cubicBezTo>
                <a:cubicBezTo>
                  <a:pt x="15494" y="61723"/>
                  <a:pt x="29337" y="66168"/>
                  <a:pt x="41909" y="62103"/>
                </a:cubicBezTo>
                <a:cubicBezTo>
                  <a:pt x="54482" y="58039"/>
                  <a:pt x="62992" y="46228"/>
                  <a:pt x="62992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2" name="Freeform 272"/>
          <p:cNvSpPr/>
          <p:nvPr/>
        </p:nvSpPr>
        <p:spPr>
          <a:xfrm>
            <a:off x="5651738" y="3344705"/>
            <a:ext cx="62992" cy="66168"/>
          </a:xfrm>
          <a:custGeom>
            <a:avLst/>
            <a:gdLst/>
            <a:ahLst/>
            <a:cxnLst/>
            <a:rect l="0" t="0" r="0" b="0"/>
            <a:pathLst>
              <a:path w="62992" h="66168">
                <a:moveTo>
                  <a:pt x="62992" y="33021"/>
                </a:moveTo>
                <a:cubicBezTo>
                  <a:pt x="62992" y="19939"/>
                  <a:pt x="54482" y="8128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9"/>
                  <a:pt x="0" y="40260"/>
                  <a:pt x="7746" y="51055"/>
                </a:cubicBezTo>
                <a:cubicBezTo>
                  <a:pt x="15494" y="61723"/>
                  <a:pt x="29337" y="66168"/>
                  <a:pt x="41909" y="62103"/>
                </a:cubicBezTo>
                <a:cubicBezTo>
                  <a:pt x="54482" y="58039"/>
                  <a:pt x="62992" y="46228"/>
                  <a:pt x="62992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3" name="Freeform 273"/>
          <p:cNvSpPr/>
          <p:nvPr/>
        </p:nvSpPr>
        <p:spPr>
          <a:xfrm>
            <a:off x="5651738" y="3344705"/>
            <a:ext cx="62992" cy="66168"/>
          </a:xfrm>
          <a:custGeom>
            <a:avLst/>
            <a:gdLst/>
            <a:ahLst/>
            <a:cxnLst/>
            <a:rect l="0" t="0" r="0" b="0"/>
            <a:pathLst>
              <a:path w="62992" h="66168">
                <a:moveTo>
                  <a:pt x="62992" y="33021"/>
                </a:moveTo>
                <a:cubicBezTo>
                  <a:pt x="62992" y="19939"/>
                  <a:pt x="54482" y="8128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9"/>
                  <a:pt x="0" y="40260"/>
                  <a:pt x="7746" y="51055"/>
                </a:cubicBezTo>
                <a:cubicBezTo>
                  <a:pt x="15494" y="61723"/>
                  <a:pt x="29337" y="66168"/>
                  <a:pt x="41909" y="62103"/>
                </a:cubicBezTo>
                <a:cubicBezTo>
                  <a:pt x="54482" y="58039"/>
                  <a:pt x="62992" y="46228"/>
                  <a:pt x="62992" y="33021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4" name="Freeform 274"/>
          <p:cNvSpPr/>
          <p:nvPr/>
        </p:nvSpPr>
        <p:spPr>
          <a:xfrm>
            <a:off x="5651738" y="2491265"/>
            <a:ext cx="62992" cy="66167"/>
          </a:xfrm>
          <a:custGeom>
            <a:avLst/>
            <a:gdLst/>
            <a:ahLst/>
            <a:cxnLst/>
            <a:rect l="0" t="0" r="0" b="0"/>
            <a:pathLst>
              <a:path w="62992" h="66167">
                <a:moveTo>
                  <a:pt x="62992" y="33148"/>
                </a:moveTo>
                <a:cubicBezTo>
                  <a:pt x="62992" y="19939"/>
                  <a:pt x="54482" y="8128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9"/>
                  <a:pt x="0" y="40260"/>
                  <a:pt x="7746" y="51054"/>
                </a:cubicBezTo>
                <a:cubicBezTo>
                  <a:pt x="15494" y="61723"/>
                  <a:pt x="29337" y="66167"/>
                  <a:pt x="41909" y="62103"/>
                </a:cubicBezTo>
                <a:cubicBezTo>
                  <a:pt x="54482" y="58039"/>
                  <a:pt x="62992" y="46228"/>
                  <a:pt x="62992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5" name="Freeform 275"/>
          <p:cNvSpPr/>
          <p:nvPr/>
        </p:nvSpPr>
        <p:spPr>
          <a:xfrm>
            <a:off x="5651738" y="2491265"/>
            <a:ext cx="62992" cy="66167"/>
          </a:xfrm>
          <a:custGeom>
            <a:avLst/>
            <a:gdLst/>
            <a:ahLst/>
            <a:cxnLst/>
            <a:rect l="0" t="0" r="0" b="0"/>
            <a:pathLst>
              <a:path w="62992" h="66167">
                <a:moveTo>
                  <a:pt x="62992" y="33148"/>
                </a:moveTo>
                <a:cubicBezTo>
                  <a:pt x="62992" y="19939"/>
                  <a:pt x="54482" y="8128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9"/>
                  <a:pt x="0" y="40260"/>
                  <a:pt x="7746" y="51054"/>
                </a:cubicBezTo>
                <a:cubicBezTo>
                  <a:pt x="15494" y="61723"/>
                  <a:pt x="29337" y="66167"/>
                  <a:pt x="41909" y="62103"/>
                </a:cubicBezTo>
                <a:cubicBezTo>
                  <a:pt x="54482" y="58039"/>
                  <a:pt x="62992" y="46228"/>
                  <a:pt x="62992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6" name="Freeform 276"/>
          <p:cNvSpPr/>
          <p:nvPr/>
        </p:nvSpPr>
        <p:spPr>
          <a:xfrm>
            <a:off x="5651738" y="2491265"/>
            <a:ext cx="62992" cy="66167"/>
          </a:xfrm>
          <a:custGeom>
            <a:avLst/>
            <a:gdLst/>
            <a:ahLst/>
            <a:cxnLst/>
            <a:rect l="0" t="0" r="0" b="0"/>
            <a:pathLst>
              <a:path w="62992" h="66167">
                <a:moveTo>
                  <a:pt x="62992" y="33148"/>
                </a:moveTo>
                <a:cubicBezTo>
                  <a:pt x="62992" y="19939"/>
                  <a:pt x="54482" y="8128"/>
                  <a:pt x="41909" y="4064"/>
                </a:cubicBezTo>
                <a:cubicBezTo>
                  <a:pt x="29337" y="0"/>
                  <a:pt x="15494" y="4446"/>
                  <a:pt x="7746" y="15113"/>
                </a:cubicBezTo>
                <a:cubicBezTo>
                  <a:pt x="0" y="25909"/>
                  <a:pt x="0" y="40260"/>
                  <a:pt x="7746" y="51054"/>
                </a:cubicBezTo>
                <a:cubicBezTo>
                  <a:pt x="15494" y="61723"/>
                  <a:pt x="29337" y="66167"/>
                  <a:pt x="41909" y="62103"/>
                </a:cubicBezTo>
                <a:cubicBezTo>
                  <a:pt x="54482" y="58039"/>
                  <a:pt x="62992" y="46228"/>
                  <a:pt x="62992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7" name="Freeform 277"/>
          <p:cNvSpPr/>
          <p:nvPr/>
        </p:nvSpPr>
        <p:spPr>
          <a:xfrm>
            <a:off x="6706345" y="4057937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148"/>
                </a:moveTo>
                <a:cubicBezTo>
                  <a:pt x="62866" y="19939"/>
                  <a:pt x="54483" y="8129"/>
                  <a:pt x="41911" y="4064"/>
                </a:cubicBezTo>
                <a:cubicBezTo>
                  <a:pt x="29338" y="0"/>
                  <a:pt x="15494" y="4445"/>
                  <a:pt x="7748" y="15113"/>
                </a:cubicBezTo>
                <a:cubicBezTo>
                  <a:pt x="0" y="25908"/>
                  <a:pt x="0" y="40259"/>
                  <a:pt x="7748" y="51055"/>
                </a:cubicBezTo>
                <a:cubicBezTo>
                  <a:pt x="15494" y="61723"/>
                  <a:pt x="29338" y="66168"/>
                  <a:pt x="41911" y="62104"/>
                </a:cubicBezTo>
                <a:cubicBezTo>
                  <a:pt x="54483" y="58039"/>
                  <a:pt x="62866" y="46229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8" name="Freeform 278"/>
          <p:cNvSpPr/>
          <p:nvPr/>
        </p:nvSpPr>
        <p:spPr>
          <a:xfrm>
            <a:off x="6706345" y="4057937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148"/>
                </a:moveTo>
                <a:cubicBezTo>
                  <a:pt x="62866" y="19939"/>
                  <a:pt x="54483" y="8129"/>
                  <a:pt x="41911" y="4064"/>
                </a:cubicBezTo>
                <a:cubicBezTo>
                  <a:pt x="29338" y="0"/>
                  <a:pt x="15494" y="4445"/>
                  <a:pt x="7748" y="15113"/>
                </a:cubicBezTo>
                <a:cubicBezTo>
                  <a:pt x="0" y="25908"/>
                  <a:pt x="0" y="40259"/>
                  <a:pt x="7748" y="51055"/>
                </a:cubicBezTo>
                <a:cubicBezTo>
                  <a:pt x="15494" y="61723"/>
                  <a:pt x="29338" y="66168"/>
                  <a:pt x="41911" y="62104"/>
                </a:cubicBezTo>
                <a:cubicBezTo>
                  <a:pt x="54483" y="58039"/>
                  <a:pt x="62866" y="46229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9" name="Freeform 279"/>
          <p:cNvSpPr/>
          <p:nvPr/>
        </p:nvSpPr>
        <p:spPr>
          <a:xfrm>
            <a:off x="6706345" y="4057937"/>
            <a:ext cx="62866" cy="66168"/>
          </a:xfrm>
          <a:custGeom>
            <a:avLst/>
            <a:gdLst/>
            <a:ahLst/>
            <a:cxnLst/>
            <a:rect l="0" t="0" r="0" b="0"/>
            <a:pathLst>
              <a:path w="62866" h="66168">
                <a:moveTo>
                  <a:pt x="62866" y="33148"/>
                </a:moveTo>
                <a:cubicBezTo>
                  <a:pt x="62866" y="19939"/>
                  <a:pt x="54483" y="8129"/>
                  <a:pt x="41911" y="4064"/>
                </a:cubicBezTo>
                <a:cubicBezTo>
                  <a:pt x="29338" y="0"/>
                  <a:pt x="15494" y="4445"/>
                  <a:pt x="7748" y="15113"/>
                </a:cubicBezTo>
                <a:cubicBezTo>
                  <a:pt x="0" y="25908"/>
                  <a:pt x="0" y="40259"/>
                  <a:pt x="7748" y="51055"/>
                </a:cubicBezTo>
                <a:cubicBezTo>
                  <a:pt x="15494" y="61723"/>
                  <a:pt x="29338" y="66168"/>
                  <a:pt x="41911" y="62104"/>
                </a:cubicBezTo>
                <a:cubicBezTo>
                  <a:pt x="54483" y="58039"/>
                  <a:pt x="62866" y="46229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0" name="Freeform 280"/>
          <p:cNvSpPr/>
          <p:nvPr/>
        </p:nvSpPr>
        <p:spPr>
          <a:xfrm>
            <a:off x="6706345" y="3509298"/>
            <a:ext cx="62866" cy="66167"/>
          </a:xfrm>
          <a:custGeom>
            <a:avLst/>
            <a:gdLst/>
            <a:ahLst/>
            <a:cxnLst/>
            <a:rect l="0" t="0" r="0" b="0"/>
            <a:pathLst>
              <a:path w="62866" h="66167">
                <a:moveTo>
                  <a:pt x="62866" y="33146"/>
                </a:moveTo>
                <a:cubicBezTo>
                  <a:pt x="62866" y="19939"/>
                  <a:pt x="54483" y="8128"/>
                  <a:pt x="41911" y="4064"/>
                </a:cubicBezTo>
                <a:cubicBezTo>
                  <a:pt x="29338" y="0"/>
                  <a:pt x="15494" y="4444"/>
                  <a:pt x="7748" y="15113"/>
                </a:cubicBezTo>
                <a:cubicBezTo>
                  <a:pt x="0" y="25907"/>
                  <a:pt x="0" y="40258"/>
                  <a:pt x="7748" y="51054"/>
                </a:cubicBezTo>
                <a:cubicBezTo>
                  <a:pt x="15494" y="61721"/>
                  <a:pt x="29338" y="66167"/>
                  <a:pt x="41911" y="62103"/>
                </a:cubicBezTo>
                <a:cubicBezTo>
                  <a:pt x="54483" y="58039"/>
                  <a:pt x="62866" y="46228"/>
                  <a:pt x="62866" y="33146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1" name="Freeform 281"/>
          <p:cNvSpPr/>
          <p:nvPr/>
        </p:nvSpPr>
        <p:spPr>
          <a:xfrm>
            <a:off x="6706345" y="3509298"/>
            <a:ext cx="62866" cy="66167"/>
          </a:xfrm>
          <a:custGeom>
            <a:avLst/>
            <a:gdLst/>
            <a:ahLst/>
            <a:cxnLst/>
            <a:rect l="0" t="0" r="0" b="0"/>
            <a:pathLst>
              <a:path w="62866" h="66167">
                <a:moveTo>
                  <a:pt x="62866" y="33146"/>
                </a:moveTo>
                <a:cubicBezTo>
                  <a:pt x="62866" y="19939"/>
                  <a:pt x="54483" y="8128"/>
                  <a:pt x="41911" y="4064"/>
                </a:cubicBezTo>
                <a:cubicBezTo>
                  <a:pt x="29338" y="0"/>
                  <a:pt x="15494" y="4444"/>
                  <a:pt x="7748" y="15113"/>
                </a:cubicBezTo>
                <a:cubicBezTo>
                  <a:pt x="0" y="25907"/>
                  <a:pt x="0" y="40258"/>
                  <a:pt x="7748" y="51054"/>
                </a:cubicBezTo>
                <a:cubicBezTo>
                  <a:pt x="15494" y="61721"/>
                  <a:pt x="29338" y="66167"/>
                  <a:pt x="41911" y="62103"/>
                </a:cubicBezTo>
                <a:cubicBezTo>
                  <a:pt x="54483" y="58039"/>
                  <a:pt x="62866" y="46228"/>
                  <a:pt x="62866" y="33146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2" name="Freeform 282"/>
          <p:cNvSpPr/>
          <p:nvPr/>
        </p:nvSpPr>
        <p:spPr>
          <a:xfrm>
            <a:off x="6706345" y="3509298"/>
            <a:ext cx="62866" cy="66167"/>
          </a:xfrm>
          <a:custGeom>
            <a:avLst/>
            <a:gdLst/>
            <a:ahLst/>
            <a:cxnLst/>
            <a:rect l="0" t="0" r="0" b="0"/>
            <a:pathLst>
              <a:path w="62866" h="66167">
                <a:moveTo>
                  <a:pt x="62866" y="33146"/>
                </a:moveTo>
                <a:cubicBezTo>
                  <a:pt x="62866" y="19939"/>
                  <a:pt x="54483" y="8128"/>
                  <a:pt x="41911" y="4064"/>
                </a:cubicBezTo>
                <a:cubicBezTo>
                  <a:pt x="29338" y="0"/>
                  <a:pt x="15494" y="4444"/>
                  <a:pt x="7748" y="15113"/>
                </a:cubicBezTo>
                <a:cubicBezTo>
                  <a:pt x="0" y="25907"/>
                  <a:pt x="0" y="40258"/>
                  <a:pt x="7748" y="51054"/>
                </a:cubicBezTo>
                <a:cubicBezTo>
                  <a:pt x="15494" y="61721"/>
                  <a:pt x="29338" y="66167"/>
                  <a:pt x="41911" y="62103"/>
                </a:cubicBezTo>
                <a:cubicBezTo>
                  <a:pt x="54483" y="58039"/>
                  <a:pt x="62866" y="46228"/>
                  <a:pt x="62866" y="33146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3" name="Freeform 283"/>
          <p:cNvSpPr/>
          <p:nvPr/>
        </p:nvSpPr>
        <p:spPr>
          <a:xfrm>
            <a:off x="6706345" y="2643665"/>
            <a:ext cx="62866" cy="66167"/>
          </a:xfrm>
          <a:custGeom>
            <a:avLst/>
            <a:gdLst/>
            <a:ahLst/>
            <a:cxnLst/>
            <a:rect l="0" t="0" r="0" b="0"/>
            <a:pathLst>
              <a:path w="62866" h="66167">
                <a:moveTo>
                  <a:pt x="62866" y="33148"/>
                </a:moveTo>
                <a:cubicBezTo>
                  <a:pt x="62866" y="19939"/>
                  <a:pt x="54483" y="8128"/>
                  <a:pt x="41911" y="4064"/>
                </a:cubicBezTo>
                <a:cubicBezTo>
                  <a:pt x="29338" y="0"/>
                  <a:pt x="15494" y="4446"/>
                  <a:pt x="7748" y="15113"/>
                </a:cubicBezTo>
                <a:cubicBezTo>
                  <a:pt x="0" y="25909"/>
                  <a:pt x="0" y="40260"/>
                  <a:pt x="7748" y="51054"/>
                </a:cubicBezTo>
                <a:cubicBezTo>
                  <a:pt x="15494" y="61723"/>
                  <a:pt x="29338" y="66167"/>
                  <a:pt x="41911" y="62103"/>
                </a:cubicBezTo>
                <a:cubicBezTo>
                  <a:pt x="54483" y="58039"/>
                  <a:pt x="62866" y="46228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4" name="Freeform 284"/>
          <p:cNvSpPr/>
          <p:nvPr/>
        </p:nvSpPr>
        <p:spPr>
          <a:xfrm>
            <a:off x="6706345" y="2643665"/>
            <a:ext cx="62866" cy="66167"/>
          </a:xfrm>
          <a:custGeom>
            <a:avLst/>
            <a:gdLst/>
            <a:ahLst/>
            <a:cxnLst/>
            <a:rect l="0" t="0" r="0" b="0"/>
            <a:pathLst>
              <a:path w="62866" h="66167">
                <a:moveTo>
                  <a:pt x="62866" y="33148"/>
                </a:moveTo>
                <a:cubicBezTo>
                  <a:pt x="62866" y="19939"/>
                  <a:pt x="54483" y="8128"/>
                  <a:pt x="41911" y="4064"/>
                </a:cubicBezTo>
                <a:cubicBezTo>
                  <a:pt x="29338" y="0"/>
                  <a:pt x="15494" y="4446"/>
                  <a:pt x="7748" y="15113"/>
                </a:cubicBezTo>
                <a:cubicBezTo>
                  <a:pt x="0" y="25909"/>
                  <a:pt x="0" y="40260"/>
                  <a:pt x="7748" y="51054"/>
                </a:cubicBezTo>
                <a:cubicBezTo>
                  <a:pt x="15494" y="61723"/>
                  <a:pt x="29338" y="66167"/>
                  <a:pt x="41911" y="62103"/>
                </a:cubicBezTo>
                <a:cubicBezTo>
                  <a:pt x="54483" y="58039"/>
                  <a:pt x="62866" y="46228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5" name="Freeform 285"/>
          <p:cNvSpPr/>
          <p:nvPr/>
        </p:nvSpPr>
        <p:spPr>
          <a:xfrm>
            <a:off x="6706345" y="2643665"/>
            <a:ext cx="62866" cy="66167"/>
          </a:xfrm>
          <a:custGeom>
            <a:avLst/>
            <a:gdLst/>
            <a:ahLst/>
            <a:cxnLst/>
            <a:rect l="0" t="0" r="0" b="0"/>
            <a:pathLst>
              <a:path w="62866" h="66167">
                <a:moveTo>
                  <a:pt x="62866" y="33148"/>
                </a:moveTo>
                <a:cubicBezTo>
                  <a:pt x="62866" y="19939"/>
                  <a:pt x="54483" y="8128"/>
                  <a:pt x="41911" y="4064"/>
                </a:cubicBezTo>
                <a:cubicBezTo>
                  <a:pt x="29338" y="0"/>
                  <a:pt x="15494" y="4446"/>
                  <a:pt x="7748" y="15113"/>
                </a:cubicBezTo>
                <a:cubicBezTo>
                  <a:pt x="0" y="25909"/>
                  <a:pt x="0" y="40260"/>
                  <a:pt x="7748" y="51054"/>
                </a:cubicBezTo>
                <a:cubicBezTo>
                  <a:pt x="15494" y="61723"/>
                  <a:pt x="29338" y="66167"/>
                  <a:pt x="41911" y="62103"/>
                </a:cubicBezTo>
                <a:cubicBezTo>
                  <a:pt x="54483" y="58039"/>
                  <a:pt x="62866" y="46228"/>
                  <a:pt x="62866" y="33148"/>
                </a:cubicBezTo>
              </a:path>
            </a:pathLst>
          </a:custGeom>
          <a:noFill/>
          <a:ln w="6095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6" name="Freeform 286"/>
          <p:cNvSpPr/>
          <p:nvPr/>
        </p:nvSpPr>
        <p:spPr>
          <a:xfrm>
            <a:off x="1422259" y="4006981"/>
            <a:ext cx="5262371" cy="84456"/>
          </a:xfrm>
          <a:custGeom>
            <a:avLst/>
            <a:gdLst/>
            <a:ahLst/>
            <a:cxnLst/>
            <a:rect l="0" t="0" r="0" b="0"/>
            <a:pathLst>
              <a:path w="5262371" h="84456">
                <a:moveTo>
                  <a:pt x="0" y="52832"/>
                </a:moveTo>
                <a:lnTo>
                  <a:pt x="0" y="52832"/>
                </a:lnTo>
                <a:lnTo>
                  <a:pt x="1052448" y="69850"/>
                </a:lnTo>
                <a:lnTo>
                  <a:pt x="2104897" y="58929"/>
                </a:lnTo>
                <a:lnTo>
                  <a:pt x="3157346" y="49657"/>
                </a:lnTo>
                <a:lnTo>
                  <a:pt x="4209922" y="0"/>
                </a:lnTo>
                <a:lnTo>
                  <a:pt x="5262371" y="84456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7" name="Freeform 287"/>
          <p:cNvSpPr/>
          <p:nvPr/>
        </p:nvSpPr>
        <p:spPr>
          <a:xfrm>
            <a:off x="1476993" y="3298858"/>
            <a:ext cx="5262245" cy="246127"/>
          </a:xfrm>
          <a:custGeom>
            <a:avLst/>
            <a:gdLst/>
            <a:ahLst/>
            <a:cxnLst/>
            <a:rect l="0" t="0" r="0" b="0"/>
            <a:pathLst>
              <a:path w="5262245" h="246127">
                <a:moveTo>
                  <a:pt x="0" y="20320"/>
                </a:moveTo>
                <a:lnTo>
                  <a:pt x="0" y="20320"/>
                </a:lnTo>
                <a:lnTo>
                  <a:pt x="1052450" y="37593"/>
                </a:lnTo>
                <a:lnTo>
                  <a:pt x="2104898" y="43561"/>
                </a:lnTo>
                <a:lnTo>
                  <a:pt x="3157347" y="0"/>
                </a:lnTo>
                <a:lnTo>
                  <a:pt x="4209796" y="79375"/>
                </a:lnTo>
                <a:lnTo>
                  <a:pt x="5262245" y="246127"/>
                </a:lnTo>
              </a:path>
            </a:pathLst>
          </a:custGeom>
          <a:noFill/>
          <a:ln w="12191" cap="flat" cmpd="sng">
            <a:solidFill>
              <a:srgbClr val="808080">
                <a:alpha val="100000"/>
              </a:srgbClr>
            </a:solidFill>
            <a:custDash>
              <a:ds d="2708333" sp="625000"/>
            </a:custDash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8" name="Freeform 288"/>
          <p:cNvSpPr/>
          <p:nvPr/>
        </p:nvSpPr>
        <p:spPr>
          <a:xfrm>
            <a:off x="6738731" y="3542444"/>
            <a:ext cx="507" cy="2541"/>
          </a:xfrm>
          <a:custGeom>
            <a:avLst/>
            <a:gdLst/>
            <a:ahLst/>
            <a:cxnLst/>
            <a:rect l="0" t="0" r="0" b="0"/>
            <a:pathLst>
              <a:path w="507" h="2541">
                <a:moveTo>
                  <a:pt x="0" y="0"/>
                </a:moveTo>
                <a:lnTo>
                  <a:pt x="507" y="2541"/>
                </a:lnTo>
              </a:path>
            </a:pathLst>
          </a:custGeom>
          <a:noFill/>
          <a:ln w="12191" cap="flat" cmpd="sng">
            <a:solidFill>
              <a:srgbClr val="80808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9" name="Freeform 289"/>
          <p:cNvSpPr/>
          <p:nvPr/>
        </p:nvSpPr>
        <p:spPr>
          <a:xfrm>
            <a:off x="1508363" y="2079786"/>
            <a:ext cx="5262372" cy="597154"/>
          </a:xfrm>
          <a:custGeom>
            <a:avLst/>
            <a:gdLst/>
            <a:ahLst/>
            <a:cxnLst/>
            <a:rect l="0" t="0" r="0" b="0"/>
            <a:pathLst>
              <a:path w="5262372" h="597154">
                <a:moveTo>
                  <a:pt x="0" y="77089"/>
                </a:moveTo>
                <a:lnTo>
                  <a:pt x="0" y="77089"/>
                </a:lnTo>
                <a:lnTo>
                  <a:pt x="1052576" y="0"/>
                </a:lnTo>
                <a:lnTo>
                  <a:pt x="2105025" y="33019"/>
                </a:lnTo>
                <a:lnTo>
                  <a:pt x="3157473" y="122428"/>
                </a:lnTo>
                <a:lnTo>
                  <a:pt x="4209922" y="446278"/>
                </a:lnTo>
                <a:lnTo>
                  <a:pt x="5262372" y="597154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custDash>
              <a:ds d="520833" sp="520833"/>
              <a:ds d="520833" sp="520833"/>
            </a:custDash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0" name="Freeform 290"/>
          <p:cNvSpPr/>
          <p:nvPr/>
        </p:nvSpPr>
        <p:spPr>
          <a:xfrm>
            <a:off x="6915514" y="2676813"/>
            <a:ext cx="382" cy="889"/>
          </a:xfrm>
          <a:custGeom>
            <a:avLst/>
            <a:gdLst/>
            <a:ahLst/>
            <a:cxnLst/>
            <a:rect l="0" t="0" r="0" b="0"/>
            <a:pathLst>
              <a:path w="382" h="889">
                <a:moveTo>
                  <a:pt x="0" y="0"/>
                </a:moveTo>
                <a:lnTo>
                  <a:pt x="382" y="889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1" name="Freeform 291"/>
          <p:cNvSpPr/>
          <p:nvPr/>
        </p:nvSpPr>
        <p:spPr>
          <a:xfrm>
            <a:off x="904478" y="4531775"/>
            <a:ext cx="6413499" cy="0"/>
          </a:xfrm>
          <a:custGeom>
            <a:avLst/>
            <a:gdLst/>
            <a:ahLst/>
            <a:cxnLst/>
            <a:rect l="0" t="0" r="0" b="0"/>
            <a:pathLst>
              <a:path w="6413499">
                <a:moveTo>
                  <a:pt x="0" y="0"/>
                </a:moveTo>
                <a:lnTo>
                  <a:pt x="641349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2" name="Freeform 292"/>
          <p:cNvSpPr/>
          <p:nvPr/>
        </p:nvSpPr>
        <p:spPr>
          <a:xfrm>
            <a:off x="7311882" y="1103790"/>
            <a:ext cx="0" cy="3427985"/>
          </a:xfrm>
          <a:custGeom>
            <a:avLst/>
            <a:gdLst/>
            <a:ahLst/>
            <a:cxnLst/>
            <a:rect l="0" t="0" r="0" b="0"/>
            <a:pathLst>
              <a:path h="3427985">
                <a:moveTo>
                  <a:pt x="0" y="342798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3" name="Freeform 293"/>
          <p:cNvSpPr/>
          <p:nvPr/>
        </p:nvSpPr>
        <p:spPr>
          <a:xfrm>
            <a:off x="904478" y="1109887"/>
            <a:ext cx="6407404" cy="0"/>
          </a:xfrm>
          <a:custGeom>
            <a:avLst/>
            <a:gdLst/>
            <a:ahLst/>
            <a:cxnLst/>
            <a:rect l="0" t="0" r="0" b="0"/>
            <a:pathLst>
              <a:path w="6407404">
                <a:moveTo>
                  <a:pt x="0" y="0"/>
                </a:moveTo>
                <a:lnTo>
                  <a:pt x="6407404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4" name="Freeform 294"/>
          <p:cNvSpPr/>
          <p:nvPr/>
        </p:nvSpPr>
        <p:spPr>
          <a:xfrm>
            <a:off x="910574" y="1103790"/>
            <a:ext cx="0" cy="3427985"/>
          </a:xfrm>
          <a:custGeom>
            <a:avLst/>
            <a:gdLst/>
            <a:ahLst/>
            <a:cxnLst/>
            <a:rect l="0" t="0" r="0" b="0"/>
            <a:pathLst>
              <a:path h="3427985">
                <a:moveTo>
                  <a:pt x="0" y="342798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5" name="Freeform 295"/>
          <p:cNvSpPr/>
          <p:nvPr/>
        </p:nvSpPr>
        <p:spPr>
          <a:xfrm>
            <a:off x="910574" y="1103790"/>
            <a:ext cx="0" cy="3427985"/>
          </a:xfrm>
          <a:custGeom>
            <a:avLst/>
            <a:gdLst/>
            <a:ahLst/>
            <a:cxnLst/>
            <a:rect l="0" t="0" r="0" b="0"/>
            <a:pathLst>
              <a:path h="3427985">
                <a:moveTo>
                  <a:pt x="0" y="3427985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6" name="Freeform 296"/>
          <p:cNvSpPr/>
          <p:nvPr/>
        </p:nvSpPr>
        <p:spPr>
          <a:xfrm>
            <a:off x="843391" y="4458750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7" name="Freeform 297"/>
          <p:cNvSpPr/>
          <p:nvPr/>
        </p:nvSpPr>
        <p:spPr>
          <a:xfrm>
            <a:off x="843391" y="4239929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8" name="Freeform 298"/>
          <p:cNvSpPr/>
          <p:nvPr/>
        </p:nvSpPr>
        <p:spPr>
          <a:xfrm>
            <a:off x="843391" y="4021107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9" name="Freeform 299"/>
          <p:cNvSpPr/>
          <p:nvPr/>
        </p:nvSpPr>
        <p:spPr>
          <a:xfrm>
            <a:off x="843391" y="3802287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0" name="Freeform 300"/>
          <p:cNvSpPr/>
          <p:nvPr/>
        </p:nvSpPr>
        <p:spPr>
          <a:xfrm>
            <a:off x="843391" y="3583465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1" name="Freeform 301"/>
          <p:cNvSpPr/>
          <p:nvPr/>
        </p:nvSpPr>
        <p:spPr>
          <a:xfrm>
            <a:off x="843391" y="3364771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2" name="Freeform 302"/>
          <p:cNvSpPr/>
          <p:nvPr/>
        </p:nvSpPr>
        <p:spPr>
          <a:xfrm>
            <a:off x="843391" y="3145951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3" name="Freeform 303"/>
          <p:cNvSpPr/>
          <p:nvPr/>
        </p:nvSpPr>
        <p:spPr>
          <a:xfrm>
            <a:off x="843391" y="2927129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4" name="Freeform 304"/>
          <p:cNvSpPr/>
          <p:nvPr/>
        </p:nvSpPr>
        <p:spPr>
          <a:xfrm>
            <a:off x="843391" y="2708308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5" name="Freeform 305"/>
          <p:cNvSpPr/>
          <p:nvPr/>
        </p:nvSpPr>
        <p:spPr>
          <a:xfrm>
            <a:off x="843391" y="2489615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6" name="Freeform 306"/>
          <p:cNvSpPr/>
          <p:nvPr/>
        </p:nvSpPr>
        <p:spPr>
          <a:xfrm>
            <a:off x="843391" y="2270793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7" name="Freeform 307"/>
          <p:cNvSpPr/>
          <p:nvPr/>
        </p:nvSpPr>
        <p:spPr>
          <a:xfrm>
            <a:off x="843391" y="2051973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8" name="Freeform 308"/>
          <p:cNvSpPr/>
          <p:nvPr/>
        </p:nvSpPr>
        <p:spPr>
          <a:xfrm>
            <a:off x="843391" y="1833152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9" name="Freeform 309"/>
          <p:cNvSpPr/>
          <p:nvPr/>
        </p:nvSpPr>
        <p:spPr>
          <a:xfrm>
            <a:off x="843391" y="1614457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0" name="Freeform 310"/>
          <p:cNvSpPr/>
          <p:nvPr/>
        </p:nvSpPr>
        <p:spPr>
          <a:xfrm>
            <a:off x="843391" y="1395637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1" name="Freeform 311"/>
          <p:cNvSpPr/>
          <p:nvPr/>
        </p:nvSpPr>
        <p:spPr>
          <a:xfrm>
            <a:off x="843391" y="1176815"/>
            <a:ext cx="61087" cy="0"/>
          </a:xfrm>
          <a:custGeom>
            <a:avLst/>
            <a:gdLst/>
            <a:ahLst/>
            <a:cxnLst/>
            <a:rect l="0" t="0" r="0" b="0"/>
            <a:pathLst>
              <a:path w="61087">
                <a:moveTo>
                  <a:pt x="6108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2" name="Freeform 312"/>
          <p:cNvSpPr/>
          <p:nvPr/>
        </p:nvSpPr>
        <p:spPr>
          <a:xfrm>
            <a:off x="904478" y="4531775"/>
            <a:ext cx="6413499" cy="0"/>
          </a:xfrm>
          <a:custGeom>
            <a:avLst/>
            <a:gdLst/>
            <a:ahLst/>
            <a:cxnLst/>
            <a:rect l="0" t="0" r="0" b="0"/>
            <a:pathLst>
              <a:path w="6413499">
                <a:moveTo>
                  <a:pt x="0" y="0"/>
                </a:moveTo>
                <a:lnTo>
                  <a:pt x="6413499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3" name="Freeform 313"/>
          <p:cNvSpPr/>
          <p:nvPr/>
        </p:nvSpPr>
        <p:spPr>
          <a:xfrm>
            <a:off x="1476993" y="4531775"/>
            <a:ext cx="0" cy="60960"/>
          </a:xfrm>
          <a:custGeom>
            <a:avLst/>
            <a:gdLst/>
            <a:ahLst/>
            <a:cxnLst/>
            <a:rect l="0" t="0" r="0" b="0"/>
            <a:pathLst>
              <a:path h="60960">
                <a:moveTo>
                  <a:pt x="0" y="0"/>
                </a:moveTo>
                <a:lnTo>
                  <a:pt x="0" y="6096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4" name="Freeform 314"/>
          <p:cNvSpPr/>
          <p:nvPr/>
        </p:nvSpPr>
        <p:spPr>
          <a:xfrm>
            <a:off x="2529443" y="4531775"/>
            <a:ext cx="0" cy="60960"/>
          </a:xfrm>
          <a:custGeom>
            <a:avLst/>
            <a:gdLst/>
            <a:ahLst/>
            <a:cxnLst/>
            <a:rect l="0" t="0" r="0" b="0"/>
            <a:pathLst>
              <a:path h="60960">
                <a:moveTo>
                  <a:pt x="0" y="0"/>
                </a:moveTo>
                <a:lnTo>
                  <a:pt x="0" y="6096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5" name="Freeform 315"/>
          <p:cNvSpPr/>
          <p:nvPr/>
        </p:nvSpPr>
        <p:spPr>
          <a:xfrm>
            <a:off x="3581891" y="4531775"/>
            <a:ext cx="0" cy="60960"/>
          </a:xfrm>
          <a:custGeom>
            <a:avLst/>
            <a:gdLst/>
            <a:ahLst/>
            <a:cxnLst/>
            <a:rect l="0" t="0" r="0" b="0"/>
            <a:pathLst>
              <a:path h="60960">
                <a:moveTo>
                  <a:pt x="0" y="0"/>
                </a:moveTo>
                <a:lnTo>
                  <a:pt x="0" y="6096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6" name="Freeform 316"/>
          <p:cNvSpPr/>
          <p:nvPr/>
        </p:nvSpPr>
        <p:spPr>
          <a:xfrm>
            <a:off x="4634340" y="4531775"/>
            <a:ext cx="0" cy="60960"/>
          </a:xfrm>
          <a:custGeom>
            <a:avLst/>
            <a:gdLst/>
            <a:ahLst/>
            <a:cxnLst/>
            <a:rect l="0" t="0" r="0" b="0"/>
            <a:pathLst>
              <a:path h="60960">
                <a:moveTo>
                  <a:pt x="0" y="0"/>
                </a:moveTo>
                <a:lnTo>
                  <a:pt x="0" y="6096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7" name="Freeform 317"/>
          <p:cNvSpPr/>
          <p:nvPr/>
        </p:nvSpPr>
        <p:spPr>
          <a:xfrm>
            <a:off x="5686789" y="4531775"/>
            <a:ext cx="0" cy="60960"/>
          </a:xfrm>
          <a:custGeom>
            <a:avLst/>
            <a:gdLst/>
            <a:ahLst/>
            <a:cxnLst/>
            <a:rect l="0" t="0" r="0" b="0"/>
            <a:pathLst>
              <a:path h="60960">
                <a:moveTo>
                  <a:pt x="0" y="0"/>
                </a:moveTo>
                <a:lnTo>
                  <a:pt x="0" y="6096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8" name="Freeform 318"/>
          <p:cNvSpPr/>
          <p:nvPr/>
        </p:nvSpPr>
        <p:spPr>
          <a:xfrm>
            <a:off x="6739238" y="4531775"/>
            <a:ext cx="0" cy="60960"/>
          </a:xfrm>
          <a:custGeom>
            <a:avLst/>
            <a:gdLst/>
            <a:ahLst/>
            <a:cxnLst/>
            <a:rect l="0" t="0" r="0" b="0"/>
            <a:pathLst>
              <a:path h="60960">
                <a:moveTo>
                  <a:pt x="0" y="0"/>
                </a:moveTo>
                <a:lnTo>
                  <a:pt x="0" y="6096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1" name="Freeform 321"/>
          <p:cNvSpPr/>
          <p:nvPr/>
        </p:nvSpPr>
        <p:spPr>
          <a:xfrm>
            <a:off x="928164" y="5508135"/>
            <a:ext cx="469391" cy="0"/>
          </a:xfrm>
          <a:custGeom>
            <a:avLst/>
            <a:gdLst/>
            <a:ahLst/>
            <a:cxnLst/>
            <a:rect l="0" t="0" r="0" b="0"/>
            <a:pathLst>
              <a:path w="469391">
                <a:moveTo>
                  <a:pt x="0" y="0"/>
                </a:moveTo>
                <a:lnTo>
                  <a:pt x="469391" y="0"/>
                </a:lnTo>
              </a:path>
            </a:pathLst>
          </a:custGeom>
          <a:noFill/>
          <a:ln w="12191" cap="flat" cmpd="sng">
            <a:solidFill>
              <a:srgbClr val="000000">
                <a:alpha val="100000"/>
              </a:srgbClr>
            </a:solidFill>
            <a:custDash>
              <a:ds d="520833" sp="520833"/>
              <a:ds d="520833" sp="520833"/>
            </a:custDash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2" name="Freeform 322"/>
          <p:cNvSpPr/>
          <p:nvPr/>
        </p:nvSpPr>
        <p:spPr>
          <a:xfrm>
            <a:off x="928164" y="5355735"/>
            <a:ext cx="469391" cy="0"/>
          </a:xfrm>
          <a:custGeom>
            <a:avLst/>
            <a:gdLst/>
            <a:ahLst/>
            <a:cxnLst/>
            <a:rect l="0" t="0" r="0" b="0"/>
            <a:pathLst>
              <a:path w="469391">
                <a:moveTo>
                  <a:pt x="0" y="0"/>
                </a:moveTo>
                <a:lnTo>
                  <a:pt x="469391" y="0"/>
                </a:lnTo>
              </a:path>
            </a:pathLst>
          </a:custGeom>
          <a:noFill/>
          <a:ln w="12191" cap="flat" cmpd="sng">
            <a:solidFill>
              <a:srgbClr val="808080">
                <a:alpha val="100000"/>
              </a:srgbClr>
            </a:solidFill>
            <a:custDash>
              <a:ds d="2708333" sp="625000"/>
            </a:custDash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3" name="Freeform 323"/>
          <p:cNvSpPr/>
          <p:nvPr/>
        </p:nvSpPr>
        <p:spPr>
          <a:xfrm>
            <a:off x="928164" y="5203335"/>
            <a:ext cx="469391" cy="0"/>
          </a:xfrm>
          <a:custGeom>
            <a:avLst/>
            <a:gdLst/>
            <a:ahLst/>
            <a:cxnLst/>
            <a:rect l="0" t="0" r="0" b="0"/>
            <a:pathLst>
              <a:path w="469391">
                <a:moveTo>
                  <a:pt x="0" y="0"/>
                </a:moveTo>
                <a:lnTo>
                  <a:pt x="469391" y="0"/>
                </a:lnTo>
              </a:path>
            </a:pathLst>
          </a:custGeom>
          <a:noFill/>
          <a:ln w="12191" cap="sq" cmpd="sng">
            <a:solidFill>
              <a:srgbClr val="000000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7" name="Rectangle 327"/>
          <p:cNvSpPr/>
          <p:nvPr/>
        </p:nvSpPr>
        <p:spPr>
          <a:xfrm>
            <a:off x="734298" y="4362204"/>
            <a:ext cx="57708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29" name="Rectangle 329"/>
          <p:cNvSpPr/>
          <p:nvPr/>
        </p:nvSpPr>
        <p:spPr>
          <a:xfrm>
            <a:off x="734298" y="4142748"/>
            <a:ext cx="57708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30" name="Rectangle 330"/>
          <p:cNvSpPr/>
          <p:nvPr/>
        </p:nvSpPr>
        <p:spPr>
          <a:xfrm>
            <a:off x="734298" y="3929388"/>
            <a:ext cx="57708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31" name="Rectangle 331"/>
          <p:cNvSpPr/>
          <p:nvPr/>
        </p:nvSpPr>
        <p:spPr>
          <a:xfrm>
            <a:off x="734298" y="3709932"/>
            <a:ext cx="57708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32" name="Rectangle 332"/>
          <p:cNvSpPr/>
          <p:nvPr/>
        </p:nvSpPr>
        <p:spPr>
          <a:xfrm>
            <a:off x="734298" y="3490476"/>
            <a:ext cx="57708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333" name="Rectangle 333"/>
          <p:cNvSpPr/>
          <p:nvPr/>
        </p:nvSpPr>
        <p:spPr>
          <a:xfrm>
            <a:off x="661146" y="3271020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34" name="Rectangle 334"/>
          <p:cNvSpPr/>
          <p:nvPr/>
        </p:nvSpPr>
        <p:spPr>
          <a:xfrm>
            <a:off x="661146" y="3051564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335" name="Rectangle 335"/>
          <p:cNvSpPr/>
          <p:nvPr/>
        </p:nvSpPr>
        <p:spPr>
          <a:xfrm>
            <a:off x="661146" y="2832108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336" name="Rectangle 336"/>
          <p:cNvSpPr/>
          <p:nvPr/>
        </p:nvSpPr>
        <p:spPr>
          <a:xfrm>
            <a:off x="661146" y="2612652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337" name="Rectangle 337"/>
          <p:cNvSpPr/>
          <p:nvPr/>
        </p:nvSpPr>
        <p:spPr>
          <a:xfrm>
            <a:off x="661146" y="2393196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338" name="Rectangle 338"/>
          <p:cNvSpPr/>
          <p:nvPr/>
        </p:nvSpPr>
        <p:spPr>
          <a:xfrm>
            <a:off x="661146" y="2173740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39" name="Rectangle 339"/>
          <p:cNvSpPr/>
          <p:nvPr/>
        </p:nvSpPr>
        <p:spPr>
          <a:xfrm>
            <a:off x="661146" y="1960380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340" name="Rectangle 340"/>
          <p:cNvSpPr/>
          <p:nvPr/>
        </p:nvSpPr>
        <p:spPr>
          <a:xfrm>
            <a:off x="661146" y="1740924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341" name="Rectangle 341"/>
          <p:cNvSpPr/>
          <p:nvPr/>
        </p:nvSpPr>
        <p:spPr>
          <a:xfrm>
            <a:off x="661146" y="1521468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sp>
        <p:nvSpPr>
          <p:cNvPr id="342" name="Rectangle 342"/>
          <p:cNvSpPr/>
          <p:nvPr/>
        </p:nvSpPr>
        <p:spPr>
          <a:xfrm>
            <a:off x="661146" y="1302012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343" name="Rectangle 343"/>
          <p:cNvSpPr/>
          <p:nvPr/>
        </p:nvSpPr>
        <p:spPr>
          <a:xfrm>
            <a:off x="661146" y="1082556"/>
            <a:ext cx="115416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344" name="Rectangle 344"/>
          <p:cNvSpPr/>
          <p:nvPr/>
        </p:nvSpPr>
        <p:spPr>
          <a:xfrm rot="-5400000">
            <a:off x="88789" y="2757058"/>
            <a:ext cx="650819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CES-D scores</a:t>
            </a:r>
          </a:p>
        </p:txBody>
      </p:sp>
      <p:sp>
        <p:nvSpPr>
          <p:cNvPr id="345" name="Rectangle 345"/>
          <p:cNvSpPr/>
          <p:nvPr/>
        </p:nvSpPr>
        <p:spPr>
          <a:xfrm>
            <a:off x="1215882" y="4612140"/>
            <a:ext cx="5787803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>
              <a:tabLst>
                <a:tab pos="1054608" algn="l"/>
                <a:tab pos="2109215" algn="l"/>
                <a:tab pos="3157727" algn="l"/>
                <a:tab pos="4139183" algn="l"/>
                <a:tab pos="5157215" algn="l"/>
              </a:tabLst>
            </a:pPr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-8 wee</a:t>
            </a:r>
            <a:r>
              <a:rPr lang="en-US" sz="800" b="0" i="0" spc="-20" baseline="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s	-6 wee</a:t>
            </a:r>
            <a:r>
              <a:rPr lang="en-US" sz="800" b="0" i="0" spc="-19" baseline="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s	-4 wee</a:t>
            </a:r>
            <a:r>
              <a:rPr lang="en-US" sz="800" b="0" i="0" spc="-20" baseline="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s	-2 wee</a:t>
            </a:r>
            <a:r>
              <a:rPr lang="en-US" sz="800" b="0" i="0" spc="-19" baseline="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s	1-18 wee</a:t>
            </a:r>
            <a:r>
              <a:rPr lang="en-US" sz="800" b="0" i="0" spc="-20" baseline="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s	19-52 wee</a:t>
            </a:r>
            <a:r>
              <a:rPr lang="en-US" sz="800" b="0" i="0" spc="-20" baseline="0" dirty="0">
                <a:latin typeface="Arial" panose="020B0604020202020204" pitchFamily="34" charset="0"/>
                <a:cs typeface="Arial" panose="020B0604020202020204" pitchFamily="34" charset="0"/>
              </a:rPr>
              <a:t>ks</a:t>
            </a:r>
          </a:p>
        </p:txBody>
      </p:sp>
      <p:sp>
        <p:nvSpPr>
          <p:cNvPr id="346" name="Rectangle 346"/>
          <p:cNvSpPr/>
          <p:nvPr/>
        </p:nvSpPr>
        <p:spPr>
          <a:xfrm>
            <a:off x="3258041" y="4841652"/>
            <a:ext cx="1243610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Wee</a:t>
            </a:r>
            <a:r>
              <a:rPr lang="en-US" sz="800" b="0" i="0" spc="-21" baseline="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s before/after de</a:t>
            </a:r>
            <a:r>
              <a:rPr lang="en-US" sz="800" b="0" i="0" spc="-48" baseline="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800" b="0" i="0" spc="-21" baseline="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800" b="0" i="0" spc="0" baseline="0" dirty="0">
                <a:latin typeface="Arial" panose="020B0604020202020204" pitchFamily="34" charset="0"/>
                <a:cs typeface="Arial" panose="020B0604020202020204" pitchFamily="34" charset="0"/>
              </a:rPr>
              <a:t>ery</a:t>
            </a:r>
          </a:p>
        </p:txBody>
      </p:sp>
      <p:sp>
        <p:nvSpPr>
          <p:cNvPr id="347" name="Rectangle 347"/>
          <p:cNvSpPr/>
          <p:nvPr/>
        </p:nvSpPr>
        <p:spPr>
          <a:xfrm>
            <a:off x="1476930" y="5413621"/>
            <a:ext cx="637995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0" i="0" spc="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Latent class</a:t>
            </a:r>
            <a:r>
              <a:rPr lang="en-US" sz="800" b="0" i="0" spc="0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en-US" sz="800" b="0" i="0" spc="0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Rectangle 348"/>
          <p:cNvSpPr/>
          <p:nvPr/>
        </p:nvSpPr>
        <p:spPr>
          <a:xfrm>
            <a:off x="1476930" y="5261221"/>
            <a:ext cx="637995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atent class 2</a:t>
            </a:r>
            <a:endParaRPr lang="en-US" sz="800" b="0" i="0" spc="0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Rectangle 349"/>
          <p:cNvSpPr/>
          <p:nvPr/>
        </p:nvSpPr>
        <p:spPr>
          <a:xfrm>
            <a:off x="1476930" y="5108821"/>
            <a:ext cx="637995" cy="12311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atent class 1</a:t>
            </a:r>
            <a:endParaRPr lang="en-US" sz="800" b="0" i="0" spc="0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Rectangle 353"/>
          <p:cNvSpPr/>
          <p:nvPr/>
        </p:nvSpPr>
        <p:spPr>
          <a:xfrm>
            <a:off x="374634" y="882235"/>
            <a:ext cx="642804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sz="10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tent classes of women based on their antenatal and postpartum depressive symptoms</a:t>
            </a:r>
            <a:r>
              <a:rPr lang="en-US" sz="8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800" b="1" i="0" spc="0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070525" y="439022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sz="800" dirty="0" smtClean="0"/>
              <a:t>//</a:t>
            </a:r>
            <a:endParaRPr lang="fi-FI" sz="8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/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9</Words>
  <Application>Microsoft Office PowerPoint</Application>
  <PresentationFormat>Custom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rchenko, Polina</dc:creator>
  <cp:lastModifiedBy>Girchenko, Polina</cp:lastModifiedBy>
  <cp:revision>6</cp:revision>
  <dcterms:modified xsi:type="dcterms:W3CDTF">2021-07-06T08:22:58Z</dcterms:modified>
</cp:coreProperties>
</file>